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9" r:id="rId3"/>
    <p:sldId id="270" r:id="rId4"/>
    <p:sldId id="271" r:id="rId5"/>
    <p:sldId id="274" r:id="rId6"/>
    <p:sldId id="276" r:id="rId7"/>
    <p:sldId id="284" r:id="rId8"/>
    <p:sldId id="281" r:id="rId9"/>
    <p:sldId id="277" r:id="rId10"/>
    <p:sldId id="283" r:id="rId11"/>
    <p:sldId id="279" r:id="rId12"/>
    <p:sldId id="280" r:id="rId13"/>
    <p:sldId id="282" r:id="rId14"/>
  </p:sldIdLst>
  <p:sldSz cx="12192000" cy="6858000"/>
  <p:notesSz cx="6858000" cy="9144000"/>
  <p:defaultTextStyle>
    <a:defPPr>
      <a:defRPr lang="pt-P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>
        <p:scale>
          <a:sx n="50" d="100"/>
          <a:sy n="50" d="100"/>
        </p:scale>
        <p:origin x="1212" y="2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4FF6BD3-4D7D-2202-7146-0FFB19E51B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E10395C6-746C-FBB9-77E9-65226C4E29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PT"/>
              <a:t>Clique para editar o estilo de subtítulo do Modelo Globa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346B2CB2-C6E5-4ACE-61D4-FD90D6E2D4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FE1CD-4F57-445F-941A-78EDFB6F9186}" type="datetimeFigureOut">
              <a:rPr lang="en-GB" smtClean="0"/>
              <a:t>10/09/2024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28CEC764-9D00-6A5A-9050-AFE145829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31B87568-522C-811B-D841-3DAC1E2FCD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C48E8-6BC0-48B1-862C-B0CD57367B5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0342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E61AD5F-EF52-393F-E948-A90891FE38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CC06C85F-C504-5134-8E78-4136C0C047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B4C9AFA9-2994-924E-82E7-797837B86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FE1CD-4F57-445F-941A-78EDFB6F9186}" type="datetimeFigureOut">
              <a:rPr lang="en-GB" smtClean="0"/>
              <a:t>10/09/2024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A9A4D513-4675-DA88-FEA6-919BD76C00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DE9BEE6F-37F5-E98B-17FA-6298BD1D4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C48E8-6BC0-48B1-862C-B0CD57367B5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6736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9CAE8644-1DAC-9905-B784-699579964A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Texto Vertical 2">
            <a:extLst>
              <a:ext uri="{FF2B5EF4-FFF2-40B4-BE49-F238E27FC236}">
                <a16:creationId xmlns:a16="http://schemas.microsoft.com/office/drawing/2014/main" id="{11ECF61F-35B5-282E-653A-C5A2B7C85E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53399E31-5475-108C-0027-768233DDC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FE1CD-4F57-445F-941A-78EDFB6F9186}" type="datetimeFigureOut">
              <a:rPr lang="en-GB" smtClean="0"/>
              <a:t>10/09/2024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D36E82C0-B1A2-92C1-9B17-AD50415BD7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51C4BA2F-A740-0295-AEC6-41AD7EBE19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C48E8-6BC0-48B1-862C-B0CD57367B5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0716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FFDA512-C40A-47B8-41A1-894F396BB9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D4EBF867-55FF-BE9E-F443-717929638E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4B7A78C0-3BAE-8792-CC1E-FE49BCE79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FE1CD-4F57-445F-941A-78EDFB6F9186}" type="datetimeFigureOut">
              <a:rPr lang="en-GB" smtClean="0"/>
              <a:t>10/09/2024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3DBFD5DE-85A0-9EBA-E468-757ACFE78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6F3CE804-FBFF-1608-A10C-9492BDB952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C48E8-6BC0-48B1-862C-B0CD57367B5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689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32E797B-66AD-3888-5C48-4A1FFA7865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C74DD1D5-08A8-2F2E-D446-5882547AF7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E35D7B77-14E5-EA25-B38B-D5430B4B3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FE1CD-4F57-445F-941A-78EDFB6F9186}" type="datetimeFigureOut">
              <a:rPr lang="en-GB" smtClean="0"/>
              <a:t>10/09/2024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350EFBC6-3179-AAA7-22F5-60FE38837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CE4DE01E-0A19-71CE-6895-ED517AB87C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C48E8-6BC0-48B1-862C-B0CD57367B5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53163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FAA0DEB-2E78-F4ED-04C7-7F67E34CDE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0C4346DE-EAFA-AC35-957A-3F082676AFA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6D499AA9-1CFE-C1F1-B613-C3E356467B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4041B519-FF5B-6EC3-E9EF-6F46E31535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FE1CD-4F57-445F-941A-78EDFB6F9186}" type="datetimeFigureOut">
              <a:rPr lang="en-GB" smtClean="0"/>
              <a:t>10/09/2024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8435C4C0-2175-7780-BA7E-2DF05639DF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41009E14-778D-0A4A-FD9B-FAAC83B093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C48E8-6BC0-48B1-862C-B0CD57367B5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10889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D104C70-9252-4926-9FEE-887C73CD1C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733BE211-8B8B-E13D-5C83-CF30145B4E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Marcador de Posição de Conteúdo 3">
            <a:extLst>
              <a:ext uri="{FF2B5EF4-FFF2-40B4-BE49-F238E27FC236}">
                <a16:creationId xmlns:a16="http://schemas.microsoft.com/office/drawing/2014/main" id="{04EF1E7D-C361-4999-0F17-A64B2072B2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5" name="Marcador de Posição do Texto 4">
            <a:extLst>
              <a:ext uri="{FF2B5EF4-FFF2-40B4-BE49-F238E27FC236}">
                <a16:creationId xmlns:a16="http://schemas.microsoft.com/office/drawing/2014/main" id="{9AECDDA1-628E-4772-2BCD-2FC253F962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Marcador de Posição de Conteúdo 5">
            <a:extLst>
              <a:ext uri="{FF2B5EF4-FFF2-40B4-BE49-F238E27FC236}">
                <a16:creationId xmlns:a16="http://schemas.microsoft.com/office/drawing/2014/main" id="{C60AEC64-D1B3-B1E4-6941-C64D7C8A61C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7" name="Marcador de Posição da Data 6">
            <a:extLst>
              <a:ext uri="{FF2B5EF4-FFF2-40B4-BE49-F238E27FC236}">
                <a16:creationId xmlns:a16="http://schemas.microsoft.com/office/drawing/2014/main" id="{A56834B2-2266-EF9A-2859-5798C2B635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FE1CD-4F57-445F-941A-78EDFB6F9186}" type="datetimeFigureOut">
              <a:rPr lang="en-GB" smtClean="0"/>
              <a:t>10/09/2024</a:t>
            </a:fld>
            <a:endParaRPr lang="en-GB"/>
          </a:p>
        </p:txBody>
      </p:sp>
      <p:sp>
        <p:nvSpPr>
          <p:cNvPr id="8" name="Marcador de Posição do Rodapé 7">
            <a:extLst>
              <a:ext uri="{FF2B5EF4-FFF2-40B4-BE49-F238E27FC236}">
                <a16:creationId xmlns:a16="http://schemas.microsoft.com/office/drawing/2014/main" id="{4E4A2318-1298-BA49-914C-EA49B6B12F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Posição do Número do Diapositivo 8">
            <a:extLst>
              <a:ext uri="{FF2B5EF4-FFF2-40B4-BE49-F238E27FC236}">
                <a16:creationId xmlns:a16="http://schemas.microsoft.com/office/drawing/2014/main" id="{76406933-C7DD-A1C2-F40E-976F6048D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C48E8-6BC0-48B1-862C-B0CD57367B5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7120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ADCD7A4-56C0-B164-11DD-5321550216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a Data 2">
            <a:extLst>
              <a:ext uri="{FF2B5EF4-FFF2-40B4-BE49-F238E27FC236}">
                <a16:creationId xmlns:a16="http://schemas.microsoft.com/office/drawing/2014/main" id="{52493C49-3751-8564-277C-999296E6A5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FE1CD-4F57-445F-941A-78EDFB6F9186}" type="datetimeFigureOut">
              <a:rPr lang="en-GB" smtClean="0"/>
              <a:t>10/09/2024</a:t>
            </a:fld>
            <a:endParaRPr lang="en-GB"/>
          </a:p>
        </p:txBody>
      </p:sp>
      <p:sp>
        <p:nvSpPr>
          <p:cNvPr id="4" name="Marcador de Posição do Rodapé 3">
            <a:extLst>
              <a:ext uri="{FF2B5EF4-FFF2-40B4-BE49-F238E27FC236}">
                <a16:creationId xmlns:a16="http://schemas.microsoft.com/office/drawing/2014/main" id="{DCF1C6F5-54DF-8738-5917-13066F4E49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Posição do Número do Diapositivo 4">
            <a:extLst>
              <a:ext uri="{FF2B5EF4-FFF2-40B4-BE49-F238E27FC236}">
                <a16:creationId xmlns:a16="http://schemas.microsoft.com/office/drawing/2014/main" id="{BBFB56D5-416C-7036-EF7B-D2A9E45E66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C48E8-6BC0-48B1-862C-B0CD57367B5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09898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Data 1">
            <a:extLst>
              <a:ext uri="{FF2B5EF4-FFF2-40B4-BE49-F238E27FC236}">
                <a16:creationId xmlns:a16="http://schemas.microsoft.com/office/drawing/2014/main" id="{B2DAE954-7D23-F744-E470-1F2FF9A1D3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FE1CD-4F57-445F-941A-78EDFB6F9186}" type="datetimeFigureOut">
              <a:rPr lang="en-GB" smtClean="0"/>
              <a:t>10/09/2024</a:t>
            </a:fld>
            <a:endParaRPr lang="en-GB"/>
          </a:p>
        </p:txBody>
      </p:sp>
      <p:sp>
        <p:nvSpPr>
          <p:cNvPr id="3" name="Marcador de Posição do Rodapé 2">
            <a:extLst>
              <a:ext uri="{FF2B5EF4-FFF2-40B4-BE49-F238E27FC236}">
                <a16:creationId xmlns:a16="http://schemas.microsoft.com/office/drawing/2014/main" id="{E489BCEF-276A-AF50-0804-37043F53C9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Posição do Número do Diapositivo 3">
            <a:extLst>
              <a:ext uri="{FF2B5EF4-FFF2-40B4-BE49-F238E27FC236}">
                <a16:creationId xmlns:a16="http://schemas.microsoft.com/office/drawing/2014/main" id="{FF750AC6-A0DA-5DCF-E782-ED72D898A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C48E8-6BC0-48B1-862C-B0CD57367B5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0118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EEF18FF-AE38-EBDD-B2AA-8B4350A6C6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e Conteúdo 2">
            <a:extLst>
              <a:ext uri="{FF2B5EF4-FFF2-40B4-BE49-F238E27FC236}">
                <a16:creationId xmlns:a16="http://schemas.microsoft.com/office/drawing/2014/main" id="{C8BA3ABF-2C74-1D02-C636-CD1D16644E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8E3EC09C-50AA-77D3-3946-2992C8E084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BE9258C3-D62C-F061-27D0-A0ECA2FE63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FE1CD-4F57-445F-941A-78EDFB6F9186}" type="datetimeFigureOut">
              <a:rPr lang="en-GB" smtClean="0"/>
              <a:t>10/09/2024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4856ABCA-C8B1-AC70-C1B6-694FAB0867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D4C4A0AB-DECC-AEDB-8452-B361FFED9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C48E8-6BC0-48B1-862C-B0CD57367B5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63545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102D0DCB-1D08-5F4E-272B-F296BD52A4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a Imagem 2">
            <a:extLst>
              <a:ext uri="{FF2B5EF4-FFF2-40B4-BE49-F238E27FC236}">
                <a16:creationId xmlns:a16="http://schemas.microsoft.com/office/drawing/2014/main" id="{7C3CBDBC-3DEB-12DE-05FF-B737DA9DC5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Posição do Texto 3">
            <a:extLst>
              <a:ext uri="{FF2B5EF4-FFF2-40B4-BE49-F238E27FC236}">
                <a16:creationId xmlns:a16="http://schemas.microsoft.com/office/drawing/2014/main" id="{B25C178B-B562-A28A-436C-88E71E0E03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Marcador de Posição da Data 4">
            <a:extLst>
              <a:ext uri="{FF2B5EF4-FFF2-40B4-BE49-F238E27FC236}">
                <a16:creationId xmlns:a16="http://schemas.microsoft.com/office/drawing/2014/main" id="{9ED17645-4616-C8FF-2BFC-58209B9DA0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0FE1CD-4F57-445F-941A-78EDFB6F9186}" type="datetimeFigureOut">
              <a:rPr lang="en-GB" smtClean="0"/>
              <a:t>10/09/2024</a:t>
            </a:fld>
            <a:endParaRPr lang="en-GB"/>
          </a:p>
        </p:txBody>
      </p:sp>
      <p:sp>
        <p:nvSpPr>
          <p:cNvPr id="6" name="Marcador de Posição do Rodapé 5">
            <a:extLst>
              <a:ext uri="{FF2B5EF4-FFF2-40B4-BE49-F238E27FC236}">
                <a16:creationId xmlns:a16="http://schemas.microsoft.com/office/drawing/2014/main" id="{6E2CAA17-B9FF-6067-5B1F-CE5EB2D98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Posição do Número do Diapositivo 6">
            <a:extLst>
              <a:ext uri="{FF2B5EF4-FFF2-40B4-BE49-F238E27FC236}">
                <a16:creationId xmlns:a16="http://schemas.microsoft.com/office/drawing/2014/main" id="{5FB6F10D-58C2-FC13-EF6E-1B4E559C0B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BC48E8-6BC0-48B1-862C-B0CD57367B5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4387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Título 1">
            <a:extLst>
              <a:ext uri="{FF2B5EF4-FFF2-40B4-BE49-F238E27FC236}">
                <a16:creationId xmlns:a16="http://schemas.microsoft.com/office/drawing/2014/main" id="{40382AE4-6EDA-B07C-8113-48B91C08E7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GB"/>
          </a:p>
        </p:txBody>
      </p:sp>
      <p:sp>
        <p:nvSpPr>
          <p:cNvPr id="3" name="Marcador de Posição do Texto 2">
            <a:extLst>
              <a:ext uri="{FF2B5EF4-FFF2-40B4-BE49-F238E27FC236}">
                <a16:creationId xmlns:a16="http://schemas.microsoft.com/office/drawing/2014/main" id="{48658302-9AFB-EB47-483A-1A823411B4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4" name="Marcador de Posição da Data 3">
            <a:extLst>
              <a:ext uri="{FF2B5EF4-FFF2-40B4-BE49-F238E27FC236}">
                <a16:creationId xmlns:a16="http://schemas.microsoft.com/office/drawing/2014/main" id="{FA1B2E21-C21A-ACE8-5A4F-81B618B008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0FE1CD-4F57-445F-941A-78EDFB6F9186}" type="datetimeFigureOut">
              <a:rPr lang="en-GB" smtClean="0"/>
              <a:t>10/09/2024</a:t>
            </a:fld>
            <a:endParaRPr lang="en-GB"/>
          </a:p>
        </p:txBody>
      </p:sp>
      <p:sp>
        <p:nvSpPr>
          <p:cNvPr id="5" name="Marcador de Posição do Rodapé 4">
            <a:extLst>
              <a:ext uri="{FF2B5EF4-FFF2-40B4-BE49-F238E27FC236}">
                <a16:creationId xmlns:a16="http://schemas.microsoft.com/office/drawing/2014/main" id="{BAECBA09-80BD-BD74-86FF-17E1AB6E35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Posição do Número do Diapositivo 5">
            <a:extLst>
              <a:ext uri="{FF2B5EF4-FFF2-40B4-BE49-F238E27FC236}">
                <a16:creationId xmlns:a16="http://schemas.microsoft.com/office/drawing/2014/main" id="{F03372A1-CE5A-0F1E-40BE-BAFAFB65FA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BC48E8-6BC0-48B1-862C-B0CD57367B50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52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P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8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emf"/><Relationship Id="rId4" Type="http://schemas.openxmlformats.org/officeDocument/2006/relationships/oleObject" Target="../embeddings/oleObject6.bin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emf"/><Relationship Id="rId4" Type="http://schemas.openxmlformats.org/officeDocument/2006/relationships/oleObject" Target="../embeddings/oleObject8.bin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C78F837-41CD-A256-6E2C-98858E3CEF8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pt-PT" b="0" i="0" dirty="0" err="1">
                <a:solidFill>
                  <a:srgbClr val="60606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</a:rPr>
              <a:t>Supplementary</a:t>
            </a:r>
            <a:r>
              <a:rPr lang="pt-PT" b="0" i="0" dirty="0">
                <a:solidFill>
                  <a:srgbClr val="60606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</a:rPr>
              <a:t> Material</a:t>
            </a:r>
            <a:endParaRPr lang="en-GB" dirty="0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D3B509D6-2BE6-6FFD-F7FE-57910CA99A36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pt-PT" b="0" i="0" dirty="0" err="1">
                <a:solidFill>
                  <a:srgbClr val="60606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</a:rPr>
              <a:t>graphic</a:t>
            </a:r>
            <a:r>
              <a:rPr lang="pt-PT" b="0" i="0" dirty="0">
                <a:solidFill>
                  <a:srgbClr val="60606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</a:rPr>
              <a:t> </a:t>
            </a:r>
            <a:r>
              <a:rPr lang="pt-PT" b="0" i="0" dirty="0" err="1">
                <a:solidFill>
                  <a:srgbClr val="606060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</a:rPr>
              <a:t>forma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7148918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a 4">
            <a:extLst>
              <a:ext uri="{FF2B5EF4-FFF2-40B4-BE49-F238E27FC236}">
                <a16:creationId xmlns:a16="http://schemas.microsoft.com/office/drawing/2014/main" id="{C4A20DF2-6F36-29C1-4283-3797380E6B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9940186"/>
              </p:ext>
            </p:extLst>
          </p:nvPr>
        </p:nvGraphicFramePr>
        <p:xfrm>
          <a:off x="2435087" y="2136914"/>
          <a:ext cx="6768549" cy="3141581"/>
        </p:xfrm>
        <a:graphic>
          <a:graphicData uri="http://schemas.openxmlformats.org/drawingml/2006/table">
            <a:tbl>
              <a:tblPr firstRow="1" firstCol="1" bandRow="1">
                <a:tableStyleId>{0505E3EF-67EA-436B-97B2-0124C06EBD24}</a:tableStyleId>
              </a:tblPr>
              <a:tblGrid>
                <a:gridCol w="2091305">
                  <a:extLst>
                    <a:ext uri="{9D8B030D-6E8A-4147-A177-3AD203B41FA5}">
                      <a16:colId xmlns:a16="http://schemas.microsoft.com/office/drawing/2014/main" val="2309914342"/>
                    </a:ext>
                  </a:extLst>
                </a:gridCol>
                <a:gridCol w="1672389">
                  <a:extLst>
                    <a:ext uri="{9D8B030D-6E8A-4147-A177-3AD203B41FA5}">
                      <a16:colId xmlns:a16="http://schemas.microsoft.com/office/drawing/2014/main" val="2555339665"/>
                    </a:ext>
                  </a:extLst>
                </a:gridCol>
                <a:gridCol w="1711842">
                  <a:extLst>
                    <a:ext uri="{9D8B030D-6E8A-4147-A177-3AD203B41FA5}">
                      <a16:colId xmlns:a16="http://schemas.microsoft.com/office/drawing/2014/main" val="1386763562"/>
                    </a:ext>
                  </a:extLst>
                </a:gridCol>
                <a:gridCol w="1293013">
                  <a:extLst>
                    <a:ext uri="{9D8B030D-6E8A-4147-A177-3AD203B41FA5}">
                      <a16:colId xmlns:a16="http://schemas.microsoft.com/office/drawing/2014/main" val="4115690845"/>
                    </a:ext>
                  </a:extLst>
                </a:gridCol>
              </a:tblGrid>
              <a:tr h="484296">
                <a:tc gridSpan="4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Psoriatic Arthritis Patients, n (%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47645456"/>
                  </a:ext>
                </a:extLst>
              </a:tr>
              <a:tr h="720101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effectLst/>
                        </a:rPr>
                        <a:t>Disease activity class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effectLst/>
                        </a:rPr>
                        <a:t>Baseline</a:t>
                      </a:r>
                      <a:br>
                        <a:rPr lang="en-US" sz="1400" dirty="0">
                          <a:effectLst/>
                        </a:rPr>
                      </a:br>
                      <a:r>
                        <a:rPr lang="en-US" sz="1400" dirty="0">
                          <a:effectLst/>
                        </a:rPr>
                        <a:t>(n=25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effectLst/>
                        </a:rPr>
                        <a:t>Month 6</a:t>
                      </a:r>
                      <a:endParaRPr lang="pt-PT" sz="1400" dirty="0">
                        <a:effectLst/>
                      </a:endParaRPr>
                    </a:p>
                    <a:p>
                      <a:pPr algn="ctr"/>
                      <a:r>
                        <a:rPr lang="en-US" sz="1400" dirty="0">
                          <a:effectLst/>
                        </a:rPr>
                        <a:t>(n=22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effectLst/>
                        </a:rPr>
                        <a:t>Month 12</a:t>
                      </a:r>
                      <a:endParaRPr lang="pt-PT" sz="1400" dirty="0">
                        <a:effectLst/>
                      </a:endParaRPr>
                    </a:p>
                    <a:p>
                      <a:pPr algn="ctr"/>
                      <a:r>
                        <a:rPr lang="en-US" sz="1400" dirty="0">
                          <a:effectLst/>
                        </a:rPr>
                        <a:t>(n=17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655195179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>
                          <a:effectLst/>
                        </a:rPr>
                        <a:t>HDA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 (56.0)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2  (9.1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1 (5.8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2018542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>
                          <a:effectLst/>
                        </a:rPr>
                        <a:t>MDA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10 (40.0)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11 (50.0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7 (41.2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35455542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>
                          <a:effectLst/>
                        </a:rPr>
                        <a:t>LDA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 1 (4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3 (13.6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 5 (29.4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23248468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>
                          <a:effectLst/>
                        </a:rPr>
                        <a:t>Remission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0 (0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6 (27.3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4 (23.5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31480388"/>
                  </a:ext>
                </a:extLst>
              </a:tr>
            </a:tbl>
          </a:graphicData>
        </a:graphic>
      </p:graphicFrame>
      <p:sp>
        <p:nvSpPr>
          <p:cNvPr id="10" name="Título 1">
            <a:extLst>
              <a:ext uri="{FF2B5EF4-FFF2-40B4-BE49-F238E27FC236}">
                <a16:creationId xmlns:a16="http://schemas.microsoft.com/office/drawing/2014/main" id="{020E0810-D25E-3367-E904-252F85B2775D}"/>
              </a:ext>
            </a:extLst>
          </p:cNvPr>
          <p:cNvSpPr txBox="1">
            <a:spLocks/>
          </p:cNvSpPr>
          <p:nvPr/>
        </p:nvSpPr>
        <p:spPr>
          <a:xfrm>
            <a:off x="0" y="185028"/>
            <a:ext cx="12192000" cy="972356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800" dirty="0" err="1">
                <a:solidFill>
                  <a:schemeClr val="bg1"/>
                </a:solidFill>
              </a:rPr>
              <a:t>Supl</a:t>
            </a:r>
            <a:r>
              <a:rPr lang="en-GB" sz="2800" dirty="0">
                <a:solidFill>
                  <a:schemeClr val="bg1"/>
                </a:solidFill>
              </a:rPr>
              <a:t>. Table 2B:  </a:t>
            </a:r>
            <a:r>
              <a:rPr lang="en-US" sz="2800" dirty="0">
                <a:solidFill>
                  <a:schemeClr val="bg1"/>
                </a:solidFill>
              </a:rPr>
              <a:t>PsA patients disease activity groups at baseline, 6-months and 12-months according to the DAS-28-4V-ESR definition</a:t>
            </a:r>
            <a:endParaRPr lang="en-GB" sz="2800" dirty="0">
              <a:solidFill>
                <a:schemeClr val="bg1"/>
              </a:solidFill>
            </a:endParaRP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B78888DB-D1F9-B4E6-DCF4-EE27F05CA005}"/>
              </a:ext>
            </a:extLst>
          </p:cNvPr>
          <p:cNvSpPr txBox="1"/>
          <p:nvPr/>
        </p:nvSpPr>
        <p:spPr>
          <a:xfrm>
            <a:off x="2435087" y="5565913"/>
            <a:ext cx="66393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DA - High disease activity, defined as DAS28 greater than 5.1; MDA - moderate activity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fined as DAS28 between 3.2 and 5.1; LDA - low activity, defined asDAS28 between 2.6 and 3.2; remission as defined by DAS28 less than 2.6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45287294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a 3">
            <a:extLst>
              <a:ext uri="{FF2B5EF4-FFF2-40B4-BE49-F238E27FC236}">
                <a16:creationId xmlns:a16="http://schemas.microsoft.com/office/drawing/2014/main" id="{84EE6805-D1B4-2F63-7924-46E6BCC0A8C7}"/>
              </a:ext>
            </a:extLst>
          </p:cNvPr>
          <p:cNvGraphicFramePr>
            <a:graphicFrameLocks noGrp="1"/>
          </p:cNvGraphicFramePr>
          <p:nvPr/>
        </p:nvGraphicFramePr>
        <p:xfrm>
          <a:off x="297712" y="2211569"/>
          <a:ext cx="11375065" cy="3189769"/>
        </p:xfrm>
        <a:graphic>
          <a:graphicData uri="http://schemas.openxmlformats.org/drawingml/2006/table">
            <a:tbl>
              <a:tblPr firstCol="1" bandRow="1">
                <a:tableStyleId>{0505E3EF-67EA-436B-97B2-0124C06EBD24}</a:tableStyleId>
              </a:tblPr>
              <a:tblGrid>
                <a:gridCol w="1063255">
                  <a:extLst>
                    <a:ext uri="{9D8B030D-6E8A-4147-A177-3AD203B41FA5}">
                      <a16:colId xmlns:a16="http://schemas.microsoft.com/office/drawing/2014/main" val="2458908875"/>
                    </a:ext>
                  </a:extLst>
                </a:gridCol>
                <a:gridCol w="1369498">
                  <a:extLst>
                    <a:ext uri="{9D8B030D-6E8A-4147-A177-3AD203B41FA5}">
                      <a16:colId xmlns:a16="http://schemas.microsoft.com/office/drawing/2014/main" val="733335259"/>
                    </a:ext>
                  </a:extLst>
                </a:gridCol>
                <a:gridCol w="1341805">
                  <a:extLst>
                    <a:ext uri="{9D8B030D-6E8A-4147-A177-3AD203B41FA5}">
                      <a16:colId xmlns:a16="http://schemas.microsoft.com/office/drawing/2014/main" val="1007478075"/>
                    </a:ext>
                  </a:extLst>
                </a:gridCol>
                <a:gridCol w="890997">
                  <a:extLst>
                    <a:ext uri="{9D8B030D-6E8A-4147-A177-3AD203B41FA5}">
                      <a16:colId xmlns:a16="http://schemas.microsoft.com/office/drawing/2014/main" val="1266917214"/>
                    </a:ext>
                  </a:extLst>
                </a:gridCol>
                <a:gridCol w="1421883">
                  <a:extLst>
                    <a:ext uri="{9D8B030D-6E8A-4147-A177-3AD203B41FA5}">
                      <a16:colId xmlns:a16="http://schemas.microsoft.com/office/drawing/2014/main" val="959316620"/>
                    </a:ext>
                  </a:extLst>
                </a:gridCol>
                <a:gridCol w="951315">
                  <a:extLst>
                    <a:ext uri="{9D8B030D-6E8A-4147-A177-3AD203B41FA5}">
                      <a16:colId xmlns:a16="http://schemas.microsoft.com/office/drawing/2014/main" val="1516711139"/>
                    </a:ext>
                  </a:extLst>
                </a:gridCol>
                <a:gridCol w="1314810">
                  <a:extLst>
                    <a:ext uri="{9D8B030D-6E8A-4147-A177-3AD203B41FA5}">
                      <a16:colId xmlns:a16="http://schemas.microsoft.com/office/drawing/2014/main" val="4163409425"/>
                    </a:ext>
                  </a:extLst>
                </a:gridCol>
                <a:gridCol w="1644052">
                  <a:extLst>
                    <a:ext uri="{9D8B030D-6E8A-4147-A177-3AD203B41FA5}">
                      <a16:colId xmlns:a16="http://schemas.microsoft.com/office/drawing/2014/main" val="2640010376"/>
                    </a:ext>
                  </a:extLst>
                </a:gridCol>
                <a:gridCol w="1377450">
                  <a:extLst>
                    <a:ext uri="{9D8B030D-6E8A-4147-A177-3AD203B41FA5}">
                      <a16:colId xmlns:a16="http://schemas.microsoft.com/office/drawing/2014/main" val="2267019446"/>
                    </a:ext>
                  </a:extLst>
                </a:gridCol>
              </a:tblGrid>
              <a:tr h="889633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TIMEPOINT (</a:t>
                      </a:r>
                      <a:r>
                        <a:rPr lang="pt-PT" sz="1400" u="none" strike="noStrike" dirty="0" err="1">
                          <a:effectLst/>
                        </a:rPr>
                        <a:t>month</a:t>
                      </a:r>
                      <a:r>
                        <a:rPr lang="pt-PT" sz="1400" u="none" strike="noStrike" dirty="0">
                          <a:effectLst/>
                        </a:rPr>
                        <a:t>)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u="none" strike="noStrike">
                          <a:effectLst/>
                        </a:rPr>
                        <a:t>SF-36-Funtional Capacity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u="none" strike="noStrike" dirty="0">
                          <a:effectLst/>
                        </a:rPr>
                        <a:t>SF-36-Physical </a:t>
                      </a:r>
                      <a:r>
                        <a:rPr lang="pt-PT" sz="1400" u="none" strike="noStrike" dirty="0" err="1">
                          <a:effectLst/>
                        </a:rPr>
                        <a:t>Aspects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u="none" strike="noStrike">
                          <a:effectLst/>
                        </a:rPr>
                        <a:t>SF-36-Pain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u="none" strike="noStrike">
                          <a:effectLst/>
                        </a:rPr>
                        <a:t>SF-36-General Health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u="none" strike="noStrike">
                          <a:effectLst/>
                        </a:rPr>
                        <a:t>SF-36-Vitality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u="none" strike="noStrike">
                          <a:effectLst/>
                        </a:rPr>
                        <a:t>SF-36-Social Aspects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u="none" strike="noStrike">
                          <a:effectLst/>
                        </a:rPr>
                        <a:t>SF-36-Emotional Aspects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PT" sz="1400" u="none" strike="noStrike">
                          <a:effectLst/>
                        </a:rPr>
                        <a:t>SF-36-Mental Health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extLst>
                  <a:ext uri="{0D108BD9-81ED-4DB2-BD59-A6C34878D82A}">
                    <a16:rowId xmlns:a16="http://schemas.microsoft.com/office/drawing/2014/main" val="1055880916"/>
                  </a:ext>
                </a:extLst>
              </a:tr>
              <a:tr h="766712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0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35.16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32.55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27.42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43.08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37.99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59.96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42.15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52.63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extLst>
                  <a:ext uri="{0D108BD9-81ED-4DB2-BD59-A6C34878D82A}">
                    <a16:rowId xmlns:a16="http://schemas.microsoft.com/office/drawing/2014/main" val="970838651"/>
                  </a:ext>
                </a:extLst>
              </a:tr>
              <a:tr h="766712"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12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74.61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76.88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71.09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56.52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58.3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>
                          <a:effectLst/>
                        </a:rPr>
                        <a:t>75</a:t>
                      </a:r>
                      <a:endParaRPr lang="pt-PT" sz="1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81.52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64.55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extLst>
                  <a:ext uri="{0D108BD9-81ED-4DB2-BD59-A6C34878D82A}">
                    <a16:rowId xmlns:a16="http://schemas.microsoft.com/office/drawing/2014/main" val="3657241666"/>
                  </a:ext>
                </a:extLst>
              </a:tr>
              <a:tr h="766712">
                <a:tc>
                  <a:txBody>
                    <a:bodyPr/>
                    <a:lstStyle/>
                    <a:p>
                      <a:pPr algn="ctr" fontAlgn="b"/>
                      <a:r>
                        <a:rPr lang="el-GR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Δ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39.45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44.33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43.67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3.44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20.31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5.04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39.37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PT" sz="1400" u="none" strike="noStrike" dirty="0">
                          <a:effectLst/>
                        </a:rPr>
                        <a:t>11.92</a:t>
                      </a:r>
                      <a:endParaRPr lang="pt-PT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135" marR="5135" marT="5135" marB="0" anchor="ctr"/>
                </a:tc>
                <a:extLst>
                  <a:ext uri="{0D108BD9-81ED-4DB2-BD59-A6C34878D82A}">
                    <a16:rowId xmlns:a16="http://schemas.microsoft.com/office/drawing/2014/main" val="438801581"/>
                  </a:ext>
                </a:extLst>
              </a:tr>
            </a:tbl>
          </a:graphicData>
        </a:graphic>
      </p:graphicFrame>
      <p:sp>
        <p:nvSpPr>
          <p:cNvPr id="5" name="Título 1">
            <a:extLst>
              <a:ext uri="{FF2B5EF4-FFF2-40B4-BE49-F238E27FC236}">
                <a16:creationId xmlns:a16="http://schemas.microsoft.com/office/drawing/2014/main" id="{25B20CD8-3389-85BB-ECE6-87076C2200D5}"/>
              </a:ext>
            </a:extLst>
          </p:cNvPr>
          <p:cNvSpPr txBox="1">
            <a:spLocks/>
          </p:cNvSpPr>
          <p:nvPr/>
        </p:nvSpPr>
        <p:spPr>
          <a:xfrm>
            <a:off x="0" y="185028"/>
            <a:ext cx="12192000" cy="972356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800" dirty="0" err="1">
                <a:solidFill>
                  <a:schemeClr val="bg1"/>
                </a:solidFill>
              </a:rPr>
              <a:t>Supl</a:t>
            </a:r>
            <a:r>
              <a:rPr lang="en-GB" sz="2800" dirty="0">
                <a:solidFill>
                  <a:schemeClr val="bg1"/>
                </a:solidFill>
              </a:rPr>
              <a:t>. Table 3:  </a:t>
            </a:r>
            <a:r>
              <a:rPr lang="en-US" sz="2800" dirty="0">
                <a:solidFill>
                  <a:schemeClr val="bg1"/>
                </a:solidFill>
              </a:rPr>
              <a:t>SF-36 scores at baseline and after 12-month of follow-up (n=80)</a:t>
            </a:r>
            <a:endParaRPr lang="en-GB" sz="28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643934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a 4">
            <a:extLst>
              <a:ext uri="{FF2B5EF4-FFF2-40B4-BE49-F238E27FC236}">
                <a16:creationId xmlns:a16="http://schemas.microsoft.com/office/drawing/2014/main" id="{C97C1A1D-9500-BC35-B52E-816F3BC869F5}"/>
              </a:ext>
            </a:extLst>
          </p:cNvPr>
          <p:cNvGraphicFramePr>
            <a:graphicFrameLocks noGrp="1"/>
          </p:cNvGraphicFramePr>
          <p:nvPr/>
        </p:nvGraphicFramePr>
        <p:xfrm>
          <a:off x="1587796" y="1373914"/>
          <a:ext cx="7884195" cy="4594469"/>
        </p:xfrm>
        <a:graphic>
          <a:graphicData uri="http://schemas.openxmlformats.org/drawingml/2006/table">
            <a:tbl>
              <a:tblPr firstRow="1" firstCol="1" bandRow="1">
                <a:tableStyleId>{0505E3EF-67EA-436B-97B2-0124C06EBD24}</a:tableStyleId>
              </a:tblPr>
              <a:tblGrid>
                <a:gridCol w="2183945">
                  <a:extLst>
                    <a:ext uri="{9D8B030D-6E8A-4147-A177-3AD203B41FA5}">
                      <a16:colId xmlns:a16="http://schemas.microsoft.com/office/drawing/2014/main" val="2309914342"/>
                    </a:ext>
                  </a:extLst>
                </a:gridCol>
                <a:gridCol w="2191737">
                  <a:extLst>
                    <a:ext uri="{9D8B030D-6E8A-4147-A177-3AD203B41FA5}">
                      <a16:colId xmlns:a16="http://schemas.microsoft.com/office/drawing/2014/main" val="2555339665"/>
                    </a:ext>
                  </a:extLst>
                </a:gridCol>
                <a:gridCol w="1818861">
                  <a:extLst>
                    <a:ext uri="{9D8B030D-6E8A-4147-A177-3AD203B41FA5}">
                      <a16:colId xmlns:a16="http://schemas.microsoft.com/office/drawing/2014/main" val="1386763562"/>
                    </a:ext>
                  </a:extLst>
                </a:gridCol>
                <a:gridCol w="1689652">
                  <a:extLst>
                    <a:ext uri="{9D8B030D-6E8A-4147-A177-3AD203B41FA5}">
                      <a16:colId xmlns:a16="http://schemas.microsoft.com/office/drawing/2014/main" val="2275257595"/>
                    </a:ext>
                  </a:extLst>
                </a:gridCol>
              </a:tblGrid>
              <a:tr h="720101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ohort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effectLst/>
                        </a:rPr>
                        <a:t>Symptom duration (months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pt-PT" sz="1400" dirty="0" err="1">
                          <a:effectLst/>
                        </a:rPr>
                        <a:t>Baseline</a:t>
                      </a:r>
                      <a:r>
                        <a:rPr lang="pt-PT" sz="1400" dirty="0">
                          <a:effectLst/>
                        </a:rPr>
                        <a:t> DAS-28-ESR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l-GR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Δ</a:t>
                      </a: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AQ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655195179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isbon LEARN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2  ± 3.5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9 ± 1.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>
                            <a:outerShdw blurRad="38100" dist="38100" dir="2700000" algn="tl">
                              <a:srgbClr val="000000">
                                <a:alpha val="43137"/>
                              </a:srgbClr>
                            </a:outerShdw>
                          </a:effectLst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93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2018542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eiden LEAC</a:t>
                      </a:r>
                      <a:r>
                        <a:rPr lang="en-US" sz="1400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</a:t>
                      </a:r>
                      <a:endParaRPr lang="pt-PT" sz="1400" baseline="300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.1 ± 5.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0 ± 1.1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535455542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ondon PEAC</a:t>
                      </a:r>
                      <a:r>
                        <a:rPr lang="en-US" sz="1400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5 ± 3.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7 ± 1.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23248468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UK</a:t>
                      </a:r>
                      <a:r>
                        <a:rPr lang="en-US" sz="1400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1 ± 4.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0 ± 1.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31480388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cotland</a:t>
                      </a: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SERA</a:t>
                      </a:r>
                      <a:r>
                        <a:rPr lang="en-US" sz="1400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4 ± NA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7 ± 1.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37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82138894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rance ESPOIR</a:t>
                      </a:r>
                      <a:r>
                        <a:rPr lang="en-US" sz="1400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.4 ± 1.7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1 ± 1.3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55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17201082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ustria</a:t>
                      </a: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EAA</a:t>
                      </a:r>
                      <a:r>
                        <a:rPr lang="en-US" sz="1400" baseline="30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.8 ± 1.6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.5 ± NA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530433422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talonia</a:t>
                      </a:r>
                      <a:r>
                        <a:rPr lang="pt-PT" sz="14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AUDIT</a:t>
                      </a:r>
                      <a:r>
                        <a:rPr lang="en-US" sz="1400" baseline="30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/>
                        <a:t>10.2 ± 12.7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621438034"/>
                  </a:ext>
                </a:extLst>
              </a:tr>
            </a:tbl>
          </a:graphicData>
        </a:graphic>
      </p:graphicFrame>
      <p:sp>
        <p:nvSpPr>
          <p:cNvPr id="7" name="Título 1">
            <a:extLst>
              <a:ext uri="{FF2B5EF4-FFF2-40B4-BE49-F238E27FC236}">
                <a16:creationId xmlns:a16="http://schemas.microsoft.com/office/drawing/2014/main" id="{5B9FB67C-F1CF-7196-6253-028DED04EED9}"/>
              </a:ext>
            </a:extLst>
          </p:cNvPr>
          <p:cNvSpPr txBox="1">
            <a:spLocks/>
          </p:cNvSpPr>
          <p:nvPr/>
        </p:nvSpPr>
        <p:spPr>
          <a:xfrm>
            <a:off x="0" y="185028"/>
            <a:ext cx="12192000" cy="972356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800" dirty="0" err="1">
                <a:solidFill>
                  <a:schemeClr val="bg1"/>
                </a:solidFill>
              </a:rPr>
              <a:t>Supl</a:t>
            </a:r>
            <a:r>
              <a:rPr lang="en-GB" sz="2800" dirty="0">
                <a:solidFill>
                  <a:schemeClr val="bg1"/>
                </a:solidFill>
              </a:rPr>
              <a:t>. Table 4: Comparison between already published early arthritis cohorts</a:t>
            </a:r>
          </a:p>
        </p:txBody>
      </p:sp>
    </p:spTree>
    <p:extLst>
      <p:ext uri="{BB962C8B-B14F-4D97-AF65-F5344CB8AC3E}">
        <p14:creationId xmlns:p14="http://schemas.microsoft.com/office/powerpoint/2010/main" val="155349834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ixaDeTexto 3">
            <a:extLst>
              <a:ext uri="{FF2B5EF4-FFF2-40B4-BE49-F238E27FC236}">
                <a16:creationId xmlns:a16="http://schemas.microsoft.com/office/drawing/2014/main" id="{DF70FE0A-94D5-2E12-8ACE-DD1EC86C97DC}"/>
              </a:ext>
            </a:extLst>
          </p:cNvPr>
          <p:cNvSpPr txBox="1"/>
          <p:nvPr/>
        </p:nvSpPr>
        <p:spPr>
          <a:xfrm>
            <a:off x="624508" y="2001374"/>
            <a:ext cx="10942983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rabicPeriod"/>
            </a:pP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van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Nie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JA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Brouwer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E, van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Gaale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FA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llaar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CF, Huizinga TW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Posthumu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MD, van der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Helm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-van Mil AH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Improve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arl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identificatio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of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rthriti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: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valuating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the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fficac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of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arl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rthriti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ecognitio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linic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n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heum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Di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2013 Aug;72(8):1295-301. doi: 10.1136/annrheumdis-2012-202289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pub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2012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ep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5. PMID: 22952388.</a:t>
            </a:r>
          </a:p>
          <a:p>
            <a:pPr marL="342900" indent="-342900">
              <a:buAutoNum type="arabicPeriod"/>
            </a:pP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omão VC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Humb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F, Kelly S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Di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icco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M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Mahto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A, Lazarou I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Hand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R, Rocher-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o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V, van der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Heijd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D, Fonseca JE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Pitzali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C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Treatment-resistan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synovitis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n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adiographic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progressio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are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increase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in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lderly-onse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heumatoi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rthriti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patient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: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finding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from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a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prospectiv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observational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longitudinal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arl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rthriti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ohor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tud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emi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rthriti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heum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2020 Aug;50(4):735-743. doi: 10.1016/j.semarthrit.2020.03.018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pub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2020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Ma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15. PMID: 32531503.</a:t>
            </a:r>
          </a:p>
          <a:p>
            <a:pPr marL="342900" indent="-342900">
              <a:buAutoNum type="arabicPeriod"/>
            </a:pP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tack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RJ, Nightingale P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Jink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C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haw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K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Herro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-Marx S, Horne R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Deighto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C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Kiel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P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Malle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C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aza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K; DELAY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tud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yndicat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Delay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betwee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the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onse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of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ymptom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n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firs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heumatolog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onsultatio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in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patient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with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heumatoi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rthriti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in the UK: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observational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tud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BMJ Open. 2019 Mar 4;9(3):e024361. doi: 10.1136/bmjopen-2018-024361. PMID: 30837252; PMCID: PMC6429945.</a:t>
            </a:r>
          </a:p>
          <a:p>
            <a:pPr marL="342900" indent="-342900">
              <a:buAutoNum type="arabicPeriod"/>
            </a:pP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Dal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J, Paterson C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Tierne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A, Ralston SH, Reid DM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Basu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N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Harvi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J, McKay ND, Saunders S, Wilson H, Munro R, Richmond R, Baxter D, McMahon M, McLaren J, Kumar V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ieber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S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McInne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I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Porter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D. The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cottish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arl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heumatoi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rthriti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(SERA)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tud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: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inceptio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ohor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n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biobank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BMC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Musculoskele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Disor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2016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Nov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9;17(1):461. doi: 10.1186/s12891-016-1318-y. PMID: 27829394; PMCID: PMC5103386.</a:t>
            </a:r>
          </a:p>
          <a:p>
            <a:pPr marL="342900" indent="-342900">
              <a:buAutoNum type="arabicPeriod"/>
            </a:pP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ombe B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Benessiano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J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Berenbaum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F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antagrel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A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Daurè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JP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Dougado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M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Fardellon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P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Fautrel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B, Flipo RM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Goupill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P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Guillemi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F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L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Loe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X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Logear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I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Mariett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X, Meyer O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avau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P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incheval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N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araux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A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chaeverbek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T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ibilia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J. The ESPOIR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ohor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: a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ten-year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follow-up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of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arl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rthriti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in France: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methodolog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n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baselin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haracteristic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of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the 813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include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patient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Join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Bon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pin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2007 Oct;74(5):440-5. doi: 10.1016/j.jbspin.2007.06.001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pub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2007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Jul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26. PMID: 17905631.</a:t>
            </a:r>
          </a:p>
          <a:p>
            <a:pPr marL="342900" indent="-342900">
              <a:buFontTx/>
              <a:buAutoNum type="arabicPeriod"/>
            </a:pP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Machol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KP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Nell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VP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tamm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TA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berl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G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teiner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G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mole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JS. The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ustria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arl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rthriti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egistr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li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xp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heumatol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2003 Sep-Oct;21(5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uppl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31):S113-7. PMID: 14969061.</a:t>
            </a:r>
          </a:p>
          <a:p>
            <a:pPr marL="342900" indent="-342900">
              <a:buFontTx/>
              <a:buAutoNum type="arabicPeriod"/>
            </a:pP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oromina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H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Narváez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J, Díaz-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Torné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C, Salvador G, Gomez-Caballero ME, de la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Fuent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D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ampo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E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oig-Vilaseca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D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lavaguera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T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Morlà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R, Torrente-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egarra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V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rasa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X, Gomez-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Puerta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JA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Möller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I, Alegre C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Graell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E, Ponce A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Lisbona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MP, Pérez-Garcia C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Fígul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R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irvent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E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Poca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V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anmartí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R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Diagnostic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n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therapeutic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dela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of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heumatoi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rthriti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and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it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elationship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with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health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are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devices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in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atalonia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The AUDIT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tudy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Reumatol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Clin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2016 May-Jun;12(3):146-50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nglish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,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panish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. doi: 10.1016/j.reuma.2015.08.002.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Epub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2015 </a:t>
            </a:r>
            <a:r>
              <a:rPr lang="pt-PT" sz="1050" b="0" i="0" dirty="0" err="1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Sep</a:t>
            </a:r>
            <a:r>
              <a:rPr lang="pt-PT" sz="1050" b="0" i="0" dirty="0">
                <a:solidFill>
                  <a:srgbClr val="212121"/>
                </a:solidFill>
                <a:effectLst/>
                <a:highlight>
                  <a:srgbClr val="FFFFFF"/>
                </a:highlight>
              </a:rPr>
              <a:t> 8. PMID: 26362843.</a:t>
            </a:r>
          </a:p>
          <a:p>
            <a:pPr marL="342900" indent="-342900">
              <a:buFontTx/>
              <a:buAutoNum type="arabicPeriod"/>
            </a:pPr>
            <a:endParaRPr lang="pt-PT" sz="1050" b="0" i="0" dirty="0">
              <a:solidFill>
                <a:srgbClr val="212121"/>
              </a:solidFill>
              <a:effectLst/>
              <a:highlight>
                <a:srgbClr val="FFFFFF"/>
              </a:highlight>
            </a:endParaRPr>
          </a:p>
          <a:p>
            <a:pPr marL="342900" indent="-342900">
              <a:buAutoNum type="arabicPeriod"/>
            </a:pPr>
            <a:endParaRPr lang="en-GB" sz="1050" dirty="0"/>
          </a:p>
        </p:txBody>
      </p:sp>
      <p:sp>
        <p:nvSpPr>
          <p:cNvPr id="5" name="Título 1">
            <a:extLst>
              <a:ext uri="{FF2B5EF4-FFF2-40B4-BE49-F238E27FC236}">
                <a16:creationId xmlns:a16="http://schemas.microsoft.com/office/drawing/2014/main" id="{2E233382-F42F-8CB7-D150-6FAF884837BF}"/>
              </a:ext>
            </a:extLst>
          </p:cNvPr>
          <p:cNvSpPr txBox="1">
            <a:spLocks/>
          </p:cNvSpPr>
          <p:nvPr/>
        </p:nvSpPr>
        <p:spPr>
          <a:xfrm>
            <a:off x="0" y="185028"/>
            <a:ext cx="12192000" cy="972356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800" dirty="0" err="1">
                <a:solidFill>
                  <a:schemeClr val="bg1"/>
                </a:solidFill>
              </a:rPr>
              <a:t>Supl</a:t>
            </a:r>
            <a:r>
              <a:rPr lang="en-GB" sz="2800" dirty="0">
                <a:solidFill>
                  <a:schemeClr val="bg1"/>
                </a:solidFill>
              </a:rPr>
              <a:t>. Table 4 References</a:t>
            </a:r>
          </a:p>
        </p:txBody>
      </p:sp>
    </p:spTree>
    <p:extLst>
      <p:ext uri="{BB962C8B-B14F-4D97-AF65-F5344CB8AC3E}">
        <p14:creationId xmlns:p14="http://schemas.microsoft.com/office/powerpoint/2010/main" val="39237068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DC249D2-1F44-534F-7E37-D84871DF989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ítulo 1">
            <a:extLst>
              <a:ext uri="{FF2B5EF4-FFF2-40B4-BE49-F238E27FC236}">
                <a16:creationId xmlns:a16="http://schemas.microsoft.com/office/drawing/2014/main" id="{2C124E93-D1A4-EE7D-33E7-657B42B13ED6}"/>
              </a:ext>
            </a:extLst>
          </p:cNvPr>
          <p:cNvSpPr txBox="1">
            <a:spLocks/>
          </p:cNvSpPr>
          <p:nvPr/>
        </p:nvSpPr>
        <p:spPr>
          <a:xfrm>
            <a:off x="0" y="185027"/>
            <a:ext cx="12192000" cy="1325563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dirty="0" err="1">
                <a:solidFill>
                  <a:schemeClr val="bg1"/>
                </a:solidFill>
              </a:rPr>
              <a:t>Supl</a:t>
            </a:r>
            <a:r>
              <a:rPr lang="en-GB" dirty="0">
                <a:solidFill>
                  <a:schemeClr val="bg1"/>
                </a:solidFill>
              </a:rPr>
              <a:t>. Figure 1: reuma.pt / early arthritis</a:t>
            </a:r>
          </a:p>
        </p:txBody>
      </p:sp>
      <p:pic>
        <p:nvPicPr>
          <p:cNvPr id="3" name="Imagem 2">
            <a:extLst>
              <a:ext uri="{FF2B5EF4-FFF2-40B4-BE49-F238E27FC236}">
                <a16:creationId xmlns:a16="http://schemas.microsoft.com/office/drawing/2014/main" id="{91F87FEB-8A2A-AF24-9CC4-DFBDFF889C9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-1" t="31316" r="82907" b="6232"/>
          <a:stretch/>
        </p:blipFill>
        <p:spPr>
          <a:xfrm>
            <a:off x="226943" y="1808922"/>
            <a:ext cx="2039179" cy="4190655"/>
          </a:xfrm>
          <a:prstGeom prst="rect">
            <a:avLst/>
          </a:prstGeom>
        </p:spPr>
      </p:pic>
      <p:pic>
        <p:nvPicPr>
          <p:cNvPr id="6" name="Imagem 5">
            <a:extLst>
              <a:ext uri="{FF2B5EF4-FFF2-40B4-BE49-F238E27FC236}">
                <a16:creationId xmlns:a16="http://schemas.microsoft.com/office/drawing/2014/main" id="{2E9BF8B8-961C-21AE-4FCA-E4605E44A5B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675" t="30870" r="1861" b="8024"/>
          <a:stretch/>
        </p:blipFill>
        <p:spPr>
          <a:xfrm>
            <a:off x="1928190" y="1808922"/>
            <a:ext cx="10176014" cy="41906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98948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ítulo 1">
            <a:extLst>
              <a:ext uri="{FF2B5EF4-FFF2-40B4-BE49-F238E27FC236}">
                <a16:creationId xmlns:a16="http://schemas.microsoft.com/office/drawing/2014/main" id="{9ADC4141-CD11-3912-3A35-26988D6FD371}"/>
              </a:ext>
            </a:extLst>
          </p:cNvPr>
          <p:cNvSpPr txBox="1">
            <a:spLocks/>
          </p:cNvSpPr>
          <p:nvPr/>
        </p:nvSpPr>
        <p:spPr>
          <a:xfrm>
            <a:off x="0" y="185027"/>
            <a:ext cx="12192000" cy="1325563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dirty="0" err="1">
                <a:solidFill>
                  <a:schemeClr val="bg1"/>
                </a:solidFill>
              </a:rPr>
              <a:t>Supl</a:t>
            </a:r>
            <a:r>
              <a:rPr lang="en-GB" dirty="0">
                <a:solidFill>
                  <a:schemeClr val="bg1"/>
                </a:solidFill>
              </a:rPr>
              <a:t>. Figure 2A: joint counts homunculus </a:t>
            </a:r>
          </a:p>
        </p:txBody>
      </p:sp>
      <p:pic>
        <p:nvPicPr>
          <p:cNvPr id="3" name="Imagem 2">
            <a:extLst>
              <a:ext uri="{FF2B5EF4-FFF2-40B4-BE49-F238E27FC236}">
                <a16:creationId xmlns:a16="http://schemas.microsoft.com/office/drawing/2014/main" id="{57D94E29-7554-FC3A-33BE-37D62FB637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96163" y="1592515"/>
            <a:ext cx="9721634" cy="50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61817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>
            <a:extLst>
              <a:ext uri="{FF2B5EF4-FFF2-40B4-BE49-F238E27FC236}">
                <a16:creationId xmlns:a16="http://schemas.microsoft.com/office/drawing/2014/main" id="{0C7856D8-5CEE-D935-96C9-F70AE9FE1DC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451" t="34638" r="49212" b="6811"/>
          <a:stretch/>
        </p:blipFill>
        <p:spPr>
          <a:xfrm>
            <a:off x="4495800" y="2029833"/>
            <a:ext cx="3200400" cy="4718838"/>
          </a:xfrm>
          <a:prstGeom prst="rect">
            <a:avLst/>
          </a:prstGeom>
        </p:spPr>
      </p:pic>
      <p:sp>
        <p:nvSpPr>
          <p:cNvPr id="6" name="Título 1">
            <a:extLst>
              <a:ext uri="{FF2B5EF4-FFF2-40B4-BE49-F238E27FC236}">
                <a16:creationId xmlns:a16="http://schemas.microsoft.com/office/drawing/2014/main" id="{FC060561-77F6-FBE9-3711-897E45CE49A2}"/>
              </a:ext>
            </a:extLst>
          </p:cNvPr>
          <p:cNvSpPr txBox="1">
            <a:spLocks/>
          </p:cNvSpPr>
          <p:nvPr/>
        </p:nvSpPr>
        <p:spPr>
          <a:xfrm>
            <a:off x="0" y="185027"/>
            <a:ext cx="12192000" cy="1325563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dirty="0" err="1">
                <a:solidFill>
                  <a:schemeClr val="bg1"/>
                </a:solidFill>
              </a:rPr>
              <a:t>Supl</a:t>
            </a:r>
            <a:r>
              <a:rPr lang="en-GB" dirty="0">
                <a:solidFill>
                  <a:schemeClr val="bg1"/>
                </a:solidFill>
              </a:rPr>
              <a:t>. Figure 2B: enthesitis homunculus </a:t>
            </a:r>
          </a:p>
        </p:txBody>
      </p:sp>
    </p:spTree>
    <p:extLst>
      <p:ext uri="{BB962C8B-B14F-4D97-AF65-F5344CB8AC3E}">
        <p14:creationId xmlns:p14="http://schemas.microsoft.com/office/powerpoint/2010/main" val="139351787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5BA74DF-AEB5-8BD3-618F-39150140830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ítulo 1">
            <a:extLst>
              <a:ext uri="{FF2B5EF4-FFF2-40B4-BE49-F238E27FC236}">
                <a16:creationId xmlns:a16="http://schemas.microsoft.com/office/drawing/2014/main" id="{FB5EACC5-3A1E-8807-FBD7-76EBD5A2DCF4}"/>
              </a:ext>
            </a:extLst>
          </p:cNvPr>
          <p:cNvSpPr txBox="1">
            <a:spLocks/>
          </p:cNvSpPr>
          <p:nvPr/>
        </p:nvSpPr>
        <p:spPr>
          <a:xfrm>
            <a:off x="0" y="185028"/>
            <a:ext cx="12192000" cy="972356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800" dirty="0" err="1">
                <a:solidFill>
                  <a:schemeClr val="bg1"/>
                </a:solidFill>
              </a:rPr>
              <a:t>Supl</a:t>
            </a:r>
            <a:r>
              <a:rPr lang="en-GB" sz="2800" dirty="0">
                <a:solidFill>
                  <a:schemeClr val="bg1"/>
                </a:solidFill>
              </a:rPr>
              <a:t>. Figure 3: </a:t>
            </a:r>
            <a:r>
              <a:rPr lang="en-US" sz="2800" dirty="0">
                <a:solidFill>
                  <a:schemeClr val="bg1"/>
                </a:solidFill>
              </a:rPr>
              <a:t>DAS-28-4V-CRP, CDAI and SDAI during the 12-months follow-up</a:t>
            </a:r>
            <a:endParaRPr lang="en-GB" sz="2800" dirty="0">
              <a:solidFill>
                <a:schemeClr val="bg1"/>
              </a:solidFill>
            </a:endParaRPr>
          </a:p>
        </p:txBody>
      </p:sp>
      <p:sp>
        <p:nvSpPr>
          <p:cNvPr id="22" name="Retângulo 21">
            <a:extLst>
              <a:ext uri="{FF2B5EF4-FFF2-40B4-BE49-F238E27FC236}">
                <a16:creationId xmlns:a16="http://schemas.microsoft.com/office/drawing/2014/main" id="{B53B7FAC-7BDD-F829-91D4-B5DA0A107018}"/>
              </a:ext>
            </a:extLst>
          </p:cNvPr>
          <p:cNvSpPr/>
          <p:nvPr/>
        </p:nvSpPr>
        <p:spPr>
          <a:xfrm>
            <a:off x="5978756" y="2067959"/>
            <a:ext cx="404278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91440" tIns="45720" rIns="91440" bIns="45720">
            <a:spAutoFit/>
          </a:bodyPr>
          <a:lstStyle/>
          <a:p>
            <a:pPr algn="ctr"/>
            <a:r>
              <a:rPr lang="pt-PT" sz="32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C</a:t>
            </a:r>
          </a:p>
        </p:txBody>
      </p:sp>
      <p:sp>
        <p:nvSpPr>
          <p:cNvPr id="23" name="Retângulo 22">
            <a:extLst>
              <a:ext uri="{FF2B5EF4-FFF2-40B4-BE49-F238E27FC236}">
                <a16:creationId xmlns:a16="http://schemas.microsoft.com/office/drawing/2014/main" id="{7FD08898-29BF-233D-CBD7-1CFFD6B33643}"/>
              </a:ext>
            </a:extLst>
          </p:cNvPr>
          <p:cNvSpPr/>
          <p:nvPr/>
        </p:nvSpPr>
        <p:spPr>
          <a:xfrm>
            <a:off x="340864" y="2105379"/>
            <a:ext cx="421910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91440" tIns="45720" rIns="91440" bIns="45720">
            <a:spAutoFit/>
          </a:bodyPr>
          <a:lstStyle/>
          <a:p>
            <a:pPr algn="ctr"/>
            <a:r>
              <a:rPr lang="pt-PT" sz="32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A</a:t>
            </a:r>
          </a:p>
        </p:txBody>
      </p:sp>
      <p:sp>
        <p:nvSpPr>
          <p:cNvPr id="24" name="Retângulo 23">
            <a:extLst>
              <a:ext uri="{FF2B5EF4-FFF2-40B4-BE49-F238E27FC236}">
                <a16:creationId xmlns:a16="http://schemas.microsoft.com/office/drawing/2014/main" id="{A7CE5205-7553-E97F-EEDB-AA91D24C68BF}"/>
              </a:ext>
            </a:extLst>
          </p:cNvPr>
          <p:cNvSpPr/>
          <p:nvPr/>
        </p:nvSpPr>
        <p:spPr>
          <a:xfrm>
            <a:off x="3249580" y="2053643"/>
            <a:ext cx="407484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91440" tIns="45720" rIns="91440" bIns="45720">
            <a:spAutoFit/>
          </a:bodyPr>
          <a:lstStyle/>
          <a:p>
            <a:pPr algn="ctr"/>
            <a:r>
              <a:rPr lang="pt-PT" sz="32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B</a:t>
            </a:r>
            <a:endParaRPr lang="pt-PT" sz="32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B0950D93-FF46-0F62-B1EB-0BD2B5EB33A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951714" y="2660585"/>
          <a:ext cx="2839932" cy="26842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925743" imgH="2764802" progId="Prism8.Document">
                  <p:embed/>
                </p:oleObj>
              </mc:Choice>
              <mc:Fallback>
                <p:oleObj name="Prism 8" r:id="rId2" imgW="2925743" imgH="2764802" progId="Prism8.Document">
                  <p:embed/>
                  <p:pic>
                    <p:nvPicPr>
                      <p:cNvPr id="2" name="Objeto 1">
                        <a:extLst>
                          <a:ext uri="{FF2B5EF4-FFF2-40B4-BE49-F238E27FC236}">
                            <a16:creationId xmlns:a16="http://schemas.microsoft.com/office/drawing/2014/main" id="{B0950D93-FF46-0F62-B1EB-0BD2B5EB33A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951714" y="2660585"/>
                        <a:ext cx="2839932" cy="26842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93BA22F6-F1B8-0040-0F36-E20E422C5CF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791646" y="2656934"/>
          <a:ext cx="2839932" cy="26916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918180" imgH="2764802" progId="Prism8.Document">
                  <p:embed/>
                </p:oleObj>
              </mc:Choice>
              <mc:Fallback>
                <p:oleObj name="Prism 8" r:id="rId4" imgW="2918180" imgH="2764802" progId="Prism8.Document">
                  <p:embed/>
                  <p:pic>
                    <p:nvPicPr>
                      <p:cNvPr id="3" name="Objeto 2">
                        <a:extLst>
                          <a:ext uri="{FF2B5EF4-FFF2-40B4-BE49-F238E27FC236}">
                            <a16:creationId xmlns:a16="http://schemas.microsoft.com/office/drawing/2014/main" id="{93BA22F6-F1B8-0040-0F36-E20E422C5C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791646" y="2656934"/>
                        <a:ext cx="2839932" cy="26916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0276BA40-7EAA-0BCC-29B2-80547D3AF88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180796" y="2563312"/>
          <a:ext cx="2915204" cy="28788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2800775" imgH="2764802" progId="Prism8.Document">
                  <p:embed/>
                </p:oleObj>
              </mc:Choice>
              <mc:Fallback>
                <p:oleObj name="Prism 8" r:id="rId6" imgW="2800775" imgH="2764802" progId="Prism8.Document">
                  <p:embed/>
                  <p:pic>
                    <p:nvPicPr>
                      <p:cNvPr id="4" name="Objeto 3">
                        <a:extLst>
                          <a:ext uri="{FF2B5EF4-FFF2-40B4-BE49-F238E27FC236}">
                            <a16:creationId xmlns:a16="http://schemas.microsoft.com/office/drawing/2014/main" id="{0276BA40-7EAA-0BCC-29B2-80547D3AF8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180796" y="2563312"/>
                        <a:ext cx="2915204" cy="28788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to 17">
            <a:extLst>
              <a:ext uri="{FF2B5EF4-FFF2-40B4-BE49-F238E27FC236}">
                <a16:creationId xmlns:a16="http://schemas.microsoft.com/office/drawing/2014/main" id="{5F1ECCAE-A65A-1EE4-A199-4ADCFA3F0B42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8288" y="2652734"/>
          <a:ext cx="2734099" cy="27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2800775" imgH="2764802" progId="Prism8.Document">
                  <p:embed/>
                </p:oleObj>
              </mc:Choice>
              <mc:Fallback>
                <p:oleObj name="Prism 8" r:id="rId8" imgW="2800775" imgH="2764802" progId="Prism8.Document">
                  <p:embed/>
                  <p:pic>
                    <p:nvPicPr>
                      <p:cNvPr id="18" name="Objeto 17">
                        <a:extLst>
                          <a:ext uri="{FF2B5EF4-FFF2-40B4-BE49-F238E27FC236}">
                            <a16:creationId xmlns:a16="http://schemas.microsoft.com/office/drawing/2014/main" id="{5F1ECCAE-A65A-1EE4-A199-4ADCFA3F0B4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28288" y="2652734"/>
                        <a:ext cx="2734099" cy="27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tângulo 4">
            <a:extLst>
              <a:ext uri="{FF2B5EF4-FFF2-40B4-BE49-F238E27FC236}">
                <a16:creationId xmlns:a16="http://schemas.microsoft.com/office/drawing/2014/main" id="{D447045D-ABF3-462B-16B8-AFE984AE8877}"/>
              </a:ext>
            </a:extLst>
          </p:cNvPr>
          <p:cNvSpPr/>
          <p:nvPr/>
        </p:nvSpPr>
        <p:spPr>
          <a:xfrm>
            <a:off x="8835856" y="2095440"/>
            <a:ext cx="437940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91440" tIns="45720" rIns="91440" bIns="45720">
            <a:spAutoFit/>
          </a:bodyPr>
          <a:lstStyle/>
          <a:p>
            <a:pPr algn="ctr"/>
            <a:r>
              <a:rPr lang="pt-PT" sz="320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D</a:t>
            </a:r>
            <a:endParaRPr lang="pt-PT" sz="32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</p:spTree>
    <p:extLst>
      <p:ext uri="{BB962C8B-B14F-4D97-AF65-F5344CB8AC3E}">
        <p14:creationId xmlns:p14="http://schemas.microsoft.com/office/powerpoint/2010/main" val="22733721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1047F42-144A-BBB1-2ED1-2541B8CE193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ítulo 1">
            <a:extLst>
              <a:ext uri="{FF2B5EF4-FFF2-40B4-BE49-F238E27FC236}">
                <a16:creationId xmlns:a16="http://schemas.microsoft.com/office/drawing/2014/main" id="{91AA7F2A-336D-C5EF-789C-729D598B0333}"/>
              </a:ext>
            </a:extLst>
          </p:cNvPr>
          <p:cNvSpPr txBox="1">
            <a:spLocks/>
          </p:cNvSpPr>
          <p:nvPr/>
        </p:nvSpPr>
        <p:spPr>
          <a:xfrm>
            <a:off x="0" y="185028"/>
            <a:ext cx="12192000" cy="972356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800" dirty="0" err="1">
                <a:solidFill>
                  <a:schemeClr val="bg1"/>
                </a:solidFill>
              </a:rPr>
              <a:t>Supl</a:t>
            </a:r>
            <a:r>
              <a:rPr lang="en-GB" sz="2800" dirty="0">
                <a:solidFill>
                  <a:schemeClr val="bg1"/>
                </a:solidFill>
              </a:rPr>
              <a:t>. Figure 4A: </a:t>
            </a:r>
            <a:r>
              <a:rPr lang="en-US" sz="2800" dirty="0">
                <a:solidFill>
                  <a:schemeClr val="bg1"/>
                </a:solidFill>
              </a:rPr>
              <a:t>CDAI and SDAI of the patients with Rheumatoid Arthritis (RA)</a:t>
            </a:r>
            <a:endParaRPr lang="en-GB" sz="2800" dirty="0">
              <a:solidFill>
                <a:schemeClr val="bg1"/>
              </a:solidFill>
            </a:endParaRPr>
          </a:p>
        </p:txBody>
      </p:sp>
      <p:sp>
        <p:nvSpPr>
          <p:cNvPr id="23" name="Retângulo 22">
            <a:extLst>
              <a:ext uri="{FF2B5EF4-FFF2-40B4-BE49-F238E27FC236}">
                <a16:creationId xmlns:a16="http://schemas.microsoft.com/office/drawing/2014/main" id="{F4FDE6C9-A15B-0C02-8000-C318E8A3B51D}"/>
              </a:ext>
            </a:extLst>
          </p:cNvPr>
          <p:cNvSpPr/>
          <p:nvPr/>
        </p:nvSpPr>
        <p:spPr>
          <a:xfrm>
            <a:off x="1802658" y="2147563"/>
            <a:ext cx="421910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91440" tIns="45720" rIns="91440" bIns="45720">
            <a:spAutoFit/>
          </a:bodyPr>
          <a:lstStyle/>
          <a:p>
            <a:pPr algn="ctr"/>
            <a:r>
              <a:rPr lang="pt-PT" sz="32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A</a:t>
            </a:r>
          </a:p>
        </p:txBody>
      </p:sp>
      <p:sp>
        <p:nvSpPr>
          <p:cNvPr id="24" name="Retângulo 23">
            <a:extLst>
              <a:ext uri="{FF2B5EF4-FFF2-40B4-BE49-F238E27FC236}">
                <a16:creationId xmlns:a16="http://schemas.microsoft.com/office/drawing/2014/main" id="{91D7401C-4706-8F2C-46DE-54FB843E2ABF}"/>
              </a:ext>
            </a:extLst>
          </p:cNvPr>
          <p:cNvSpPr/>
          <p:nvPr/>
        </p:nvSpPr>
        <p:spPr>
          <a:xfrm>
            <a:off x="6420161" y="2147563"/>
            <a:ext cx="407484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91440" tIns="45720" rIns="91440" bIns="45720">
            <a:spAutoFit/>
          </a:bodyPr>
          <a:lstStyle/>
          <a:p>
            <a:pPr algn="ctr"/>
            <a:r>
              <a:rPr lang="pt-PT" sz="32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B</a:t>
            </a:r>
            <a:endParaRPr lang="pt-PT" sz="32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graphicFrame>
        <p:nvGraphicFramePr>
          <p:cNvPr id="6" name="Objeto 5">
            <a:extLst>
              <a:ext uri="{FF2B5EF4-FFF2-40B4-BE49-F238E27FC236}">
                <a16:creationId xmlns:a16="http://schemas.microsoft.com/office/drawing/2014/main" id="{36043407-9BC3-F5BF-832B-C408CFE8EA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2216157"/>
              </p:ext>
            </p:extLst>
          </p:nvPr>
        </p:nvGraphicFramePr>
        <p:xfrm>
          <a:off x="7098626" y="2067205"/>
          <a:ext cx="3572434" cy="338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919620" imgH="2764802" progId="Prism8.Document">
                  <p:embed/>
                </p:oleObj>
              </mc:Choice>
              <mc:Fallback>
                <p:oleObj name="Prism 8" r:id="rId2" imgW="2919620" imgH="2764802" progId="Prism8.Document">
                  <p:embed/>
                  <p:pic>
                    <p:nvPicPr>
                      <p:cNvPr id="6" name="Objeto 5">
                        <a:extLst>
                          <a:ext uri="{FF2B5EF4-FFF2-40B4-BE49-F238E27FC236}">
                            <a16:creationId xmlns:a16="http://schemas.microsoft.com/office/drawing/2014/main" id="{36043407-9BC3-F5BF-832B-C408CFE8EA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098626" y="2067205"/>
                        <a:ext cx="3572434" cy="338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CCF770D0-9D63-CA6B-100D-0EAB84EB04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7813579"/>
              </p:ext>
            </p:extLst>
          </p:nvPr>
        </p:nvGraphicFramePr>
        <p:xfrm>
          <a:off x="2495551" y="2067205"/>
          <a:ext cx="3576318" cy="338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922501" imgH="2764802" progId="Prism8.Document">
                  <p:embed/>
                </p:oleObj>
              </mc:Choice>
              <mc:Fallback>
                <p:oleObj name="Prism 8" r:id="rId4" imgW="2922501" imgH="276480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495551" y="2067205"/>
                        <a:ext cx="3576318" cy="338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6686503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1047F42-144A-BBB1-2ED1-2541B8CE193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ítulo 1">
            <a:extLst>
              <a:ext uri="{FF2B5EF4-FFF2-40B4-BE49-F238E27FC236}">
                <a16:creationId xmlns:a16="http://schemas.microsoft.com/office/drawing/2014/main" id="{91AA7F2A-336D-C5EF-789C-729D598B0333}"/>
              </a:ext>
            </a:extLst>
          </p:cNvPr>
          <p:cNvSpPr txBox="1">
            <a:spLocks/>
          </p:cNvSpPr>
          <p:nvPr/>
        </p:nvSpPr>
        <p:spPr>
          <a:xfrm>
            <a:off x="0" y="185028"/>
            <a:ext cx="12192000" cy="972356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800" dirty="0" err="1">
                <a:solidFill>
                  <a:schemeClr val="bg1"/>
                </a:solidFill>
              </a:rPr>
              <a:t>Supl</a:t>
            </a:r>
            <a:r>
              <a:rPr lang="en-GB" sz="2800" dirty="0">
                <a:solidFill>
                  <a:schemeClr val="bg1"/>
                </a:solidFill>
              </a:rPr>
              <a:t>. Figure 4B: </a:t>
            </a:r>
            <a:r>
              <a:rPr lang="en-US" sz="2800" dirty="0">
                <a:solidFill>
                  <a:schemeClr val="bg1"/>
                </a:solidFill>
              </a:rPr>
              <a:t>CDAI and SDAI of the patients with Psoriatic Arthritis (PsA)</a:t>
            </a:r>
            <a:endParaRPr lang="en-GB" sz="2800" dirty="0">
              <a:solidFill>
                <a:schemeClr val="bg1"/>
              </a:solidFill>
            </a:endParaRPr>
          </a:p>
        </p:txBody>
      </p:sp>
      <p:sp>
        <p:nvSpPr>
          <p:cNvPr id="23" name="Retângulo 22">
            <a:extLst>
              <a:ext uri="{FF2B5EF4-FFF2-40B4-BE49-F238E27FC236}">
                <a16:creationId xmlns:a16="http://schemas.microsoft.com/office/drawing/2014/main" id="{F4FDE6C9-A15B-0C02-8000-C318E8A3B51D}"/>
              </a:ext>
            </a:extLst>
          </p:cNvPr>
          <p:cNvSpPr/>
          <p:nvPr/>
        </p:nvSpPr>
        <p:spPr>
          <a:xfrm>
            <a:off x="1802658" y="2147563"/>
            <a:ext cx="421910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lIns="91440" tIns="45720" rIns="91440" bIns="45720">
            <a:spAutoFit/>
          </a:bodyPr>
          <a:lstStyle/>
          <a:p>
            <a:pPr algn="ctr"/>
            <a:r>
              <a:rPr lang="pt-PT" sz="3200" b="0" cap="none" spc="0" dirty="0">
                <a:ln w="0"/>
                <a:solidFill>
                  <a:schemeClr val="tx1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A</a:t>
            </a:r>
          </a:p>
        </p:txBody>
      </p:sp>
      <p:sp>
        <p:nvSpPr>
          <p:cNvPr id="24" name="Retângulo 23">
            <a:extLst>
              <a:ext uri="{FF2B5EF4-FFF2-40B4-BE49-F238E27FC236}">
                <a16:creationId xmlns:a16="http://schemas.microsoft.com/office/drawing/2014/main" id="{91D7401C-4706-8F2C-46DE-54FB843E2ABF}"/>
              </a:ext>
            </a:extLst>
          </p:cNvPr>
          <p:cNvSpPr/>
          <p:nvPr/>
        </p:nvSpPr>
        <p:spPr>
          <a:xfrm>
            <a:off x="6420161" y="2147563"/>
            <a:ext cx="407484" cy="58477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91440" tIns="45720" rIns="91440" bIns="45720">
            <a:spAutoFit/>
          </a:bodyPr>
          <a:lstStyle/>
          <a:p>
            <a:pPr algn="ctr"/>
            <a:r>
              <a:rPr lang="pt-PT" sz="3200" dirty="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B</a:t>
            </a:r>
            <a:endParaRPr lang="pt-PT" sz="3200" b="0" cap="none" spc="0" dirty="0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graphicFrame>
        <p:nvGraphicFramePr>
          <p:cNvPr id="2" name="Objeto 1">
            <a:extLst>
              <a:ext uri="{FF2B5EF4-FFF2-40B4-BE49-F238E27FC236}">
                <a16:creationId xmlns:a16="http://schemas.microsoft.com/office/drawing/2014/main" id="{A18A3825-2DB3-18BD-5EAF-DEC61AD0BD6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398183"/>
              </p:ext>
            </p:extLst>
          </p:nvPr>
        </p:nvGraphicFramePr>
        <p:xfrm>
          <a:off x="7397741" y="2096924"/>
          <a:ext cx="3525817" cy="338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881446" imgH="2764802" progId="Prism8.Document">
                  <p:embed/>
                </p:oleObj>
              </mc:Choice>
              <mc:Fallback>
                <p:oleObj name="Prism 8" r:id="rId2" imgW="2881446" imgH="276480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7397741" y="2096924"/>
                        <a:ext cx="3525817" cy="338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to 2">
            <a:extLst>
              <a:ext uri="{FF2B5EF4-FFF2-40B4-BE49-F238E27FC236}">
                <a16:creationId xmlns:a16="http://schemas.microsoft.com/office/drawing/2014/main" id="{D6D107B7-2121-6B7D-3FC1-4E30A0E387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6524225"/>
              </p:ext>
            </p:extLst>
          </p:nvPr>
        </p:nvGraphicFramePr>
        <p:xfrm>
          <a:off x="2573329" y="2096924"/>
          <a:ext cx="3521919" cy="338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2878565" imgH="2764802" progId="Prism8.Document">
                  <p:embed/>
                </p:oleObj>
              </mc:Choice>
              <mc:Fallback>
                <p:oleObj name="Prism 8" r:id="rId4" imgW="2878565" imgH="276480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573329" y="2096924"/>
                        <a:ext cx="3521919" cy="3384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7000521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ela 3">
            <a:extLst>
              <a:ext uri="{FF2B5EF4-FFF2-40B4-BE49-F238E27FC236}">
                <a16:creationId xmlns:a16="http://schemas.microsoft.com/office/drawing/2014/main" id="{A58D80E4-8BBB-C30F-C123-BE35D89FA251}"/>
              </a:ext>
            </a:extLst>
          </p:cNvPr>
          <p:cNvGraphicFramePr>
            <a:graphicFrameLocks noGrp="1"/>
          </p:cNvGraphicFramePr>
          <p:nvPr/>
        </p:nvGraphicFramePr>
        <p:xfrm>
          <a:off x="954158" y="1327981"/>
          <a:ext cx="10515599" cy="4748963"/>
        </p:xfrm>
        <a:graphic>
          <a:graphicData uri="http://schemas.openxmlformats.org/drawingml/2006/table">
            <a:tbl>
              <a:tblPr firstRow="1" firstCol="1" bandRow="1">
                <a:tableStyleId>{F5AB1C69-6EDB-4FF4-983F-18BD219EF322}</a:tableStyleId>
              </a:tblPr>
              <a:tblGrid>
                <a:gridCol w="1699591">
                  <a:extLst>
                    <a:ext uri="{9D8B030D-6E8A-4147-A177-3AD203B41FA5}">
                      <a16:colId xmlns:a16="http://schemas.microsoft.com/office/drawing/2014/main" val="1609990053"/>
                    </a:ext>
                  </a:extLst>
                </a:gridCol>
                <a:gridCol w="1414067">
                  <a:extLst>
                    <a:ext uri="{9D8B030D-6E8A-4147-A177-3AD203B41FA5}">
                      <a16:colId xmlns:a16="http://schemas.microsoft.com/office/drawing/2014/main" val="3379632687"/>
                    </a:ext>
                  </a:extLst>
                </a:gridCol>
                <a:gridCol w="1563044">
                  <a:extLst>
                    <a:ext uri="{9D8B030D-6E8A-4147-A177-3AD203B41FA5}">
                      <a16:colId xmlns:a16="http://schemas.microsoft.com/office/drawing/2014/main" val="2389233298"/>
                    </a:ext>
                  </a:extLst>
                </a:gridCol>
                <a:gridCol w="3100399">
                  <a:extLst>
                    <a:ext uri="{9D8B030D-6E8A-4147-A177-3AD203B41FA5}">
                      <a16:colId xmlns:a16="http://schemas.microsoft.com/office/drawing/2014/main" val="3954523645"/>
                    </a:ext>
                  </a:extLst>
                </a:gridCol>
                <a:gridCol w="2738498">
                  <a:extLst>
                    <a:ext uri="{9D8B030D-6E8A-4147-A177-3AD203B41FA5}">
                      <a16:colId xmlns:a16="http://schemas.microsoft.com/office/drawing/2014/main" val="1700581505"/>
                    </a:ext>
                  </a:extLst>
                </a:gridCol>
              </a:tblGrid>
              <a:tr h="572972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highlight>
                            <a:srgbClr val="A5A5A5"/>
                          </a:highlight>
                        </a:rPr>
                        <a:t>Treatment</a:t>
                      </a:r>
                      <a:endParaRPr lang="pt-PT" sz="1400">
                        <a:effectLst/>
                        <a:highlight>
                          <a:srgbClr val="A5A5A5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highlight>
                            <a:srgbClr val="A5A5A5"/>
                          </a:highlight>
                        </a:rPr>
                        <a:t>Patients, n* (%)</a:t>
                      </a:r>
                      <a:endParaRPr lang="pt-PT" sz="1400">
                        <a:effectLst/>
                        <a:highlight>
                          <a:srgbClr val="A5A5A5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  <a:highlight>
                            <a:srgbClr val="A5A5A5"/>
                          </a:highlight>
                        </a:rPr>
                        <a:t>Mean dose (</a:t>
                      </a:r>
                      <a:r>
                        <a:rPr lang="en-US" sz="1400" dirty="0" err="1">
                          <a:effectLst/>
                          <a:highlight>
                            <a:srgbClr val="A5A5A5"/>
                          </a:highlight>
                        </a:rPr>
                        <a:t>mg±SD</a:t>
                      </a:r>
                      <a:r>
                        <a:rPr lang="en-US" sz="1400" dirty="0">
                          <a:effectLst/>
                          <a:highlight>
                            <a:srgbClr val="A5A5A5"/>
                          </a:highlight>
                        </a:rPr>
                        <a:t>)</a:t>
                      </a:r>
                      <a:endParaRPr lang="pt-PT" sz="1400" dirty="0">
                        <a:effectLst/>
                        <a:highlight>
                          <a:srgbClr val="A5A5A5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highlight>
                            <a:srgbClr val="A5A5A5"/>
                          </a:highlight>
                        </a:rPr>
                        <a:t>Mean Cumulative dose (mg±SD)</a:t>
                      </a:r>
                      <a:endParaRPr lang="pt-PT" sz="1400">
                        <a:effectLst/>
                        <a:highlight>
                          <a:srgbClr val="A5A5A5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>
                          <a:effectLst/>
                          <a:highlight>
                            <a:srgbClr val="A5A5A5"/>
                          </a:highlight>
                        </a:rPr>
                        <a:t>Mean time on drug (months±SD)</a:t>
                      </a:r>
                      <a:endParaRPr lang="pt-PT" sz="1400">
                        <a:effectLst/>
                        <a:highlight>
                          <a:srgbClr val="A5A5A5"/>
                        </a:highlight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373" marR="51373" marT="0" marB="0"/>
                </a:tc>
                <a:extLst>
                  <a:ext uri="{0D108BD9-81ED-4DB2-BD59-A6C34878D82A}">
                    <a16:rowId xmlns:a16="http://schemas.microsoft.com/office/drawing/2014/main" val="1291832698"/>
                  </a:ext>
                </a:extLst>
              </a:tr>
              <a:tr h="315738">
                <a:tc>
                  <a:txBody>
                    <a:bodyPr/>
                    <a:lstStyle/>
                    <a:p>
                      <a:pPr marL="0" algn="just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ednisolone</a:t>
                      </a:r>
                      <a:endParaRPr lang="pt-PT" sz="1400" b="1" kern="1200" dirty="0">
                        <a:solidFill>
                          <a:schemeClr val="lt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78 (88.1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.4 (±3.9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277.6 (±2413.4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.9 (±2.5)</a:t>
                      </a:r>
                      <a:endParaRPr lang="pt-PT" sz="1400" kern="12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extLst>
                  <a:ext uri="{0D108BD9-81ED-4DB2-BD59-A6C34878D82A}">
                    <a16:rowId xmlns:a16="http://schemas.microsoft.com/office/drawing/2014/main" val="633176155"/>
                  </a:ext>
                </a:extLst>
              </a:tr>
              <a:tr h="1066882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Methotrexate</a:t>
                      </a:r>
                      <a:endParaRPr lang="pt-PT" sz="1400" dirty="0">
                        <a:effectLst/>
                      </a:endParaRPr>
                    </a:p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   Oral</a:t>
                      </a:r>
                      <a:endParaRPr lang="pt-PT" sz="1400" dirty="0">
                        <a:effectLst/>
                      </a:endParaRPr>
                    </a:p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   Subcutaneous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52 (75.3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12 (55.5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0 (19.8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4.5 (±3.4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4.0 (±3.2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5.8 (±3.4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96.8 (±263.0)</a:t>
                      </a:r>
                      <a:endParaRPr lang="pt-PT" sz="1400" kern="12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56.7 (±21.4)</a:t>
                      </a:r>
                      <a:endParaRPr lang="pt-PT" sz="1400" kern="12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01.0 (±24.1)</a:t>
                      </a:r>
                      <a:endParaRPr lang="pt-PT" sz="1400" kern="12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1.0 (±2.6)</a:t>
                      </a:r>
                      <a:endParaRPr lang="pt-PT" sz="1400" kern="12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1.6 (±2.6)</a:t>
                      </a:r>
                      <a:endParaRPr lang="pt-PT" sz="1400" kern="12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.6 (±2.0)</a:t>
                      </a:r>
                      <a:endParaRPr lang="pt-PT" sz="1400" kern="12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extLst>
                  <a:ext uri="{0D108BD9-81ED-4DB2-BD59-A6C34878D82A}">
                    <a16:rowId xmlns:a16="http://schemas.microsoft.com/office/drawing/2014/main" val="792797980"/>
                  </a:ext>
                </a:extLst>
              </a:tr>
              <a:tr h="270872">
                <a:tc>
                  <a:txBody>
                    <a:bodyPr/>
                    <a:lstStyle/>
                    <a:p>
                      <a:pPr marL="0" algn="just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eflunomide</a:t>
                      </a:r>
                      <a:endParaRPr lang="pt-PT" sz="1400" b="1" kern="1200" dirty="0">
                        <a:solidFill>
                          <a:schemeClr val="lt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 (4.46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5.7 (±4.4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369.4 (±2234.6)</a:t>
                      </a:r>
                      <a:endParaRPr lang="pt-PT" sz="1400" kern="12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.9 (±3.3)</a:t>
                      </a:r>
                      <a:endParaRPr lang="pt-PT" sz="1400" kern="12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extLst>
                  <a:ext uri="{0D108BD9-81ED-4DB2-BD59-A6C34878D82A}">
                    <a16:rowId xmlns:a16="http://schemas.microsoft.com/office/drawing/2014/main" val="4198117765"/>
                  </a:ext>
                </a:extLst>
              </a:tr>
              <a:tr h="315738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</a:pPr>
                      <a:r>
                        <a:rPr lang="en-US" sz="1400">
                          <a:effectLst/>
                        </a:rPr>
                        <a:t>Sulfasalazine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9 (9.4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700 (±500.5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71.8 (±282.4)</a:t>
                      </a:r>
                      <a:endParaRPr lang="pt-PT" sz="1400" kern="12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.3 (±3.4)</a:t>
                      </a:r>
                      <a:endParaRPr lang="pt-PT" sz="1400" kern="12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extLst>
                  <a:ext uri="{0D108BD9-81ED-4DB2-BD59-A6C34878D82A}">
                    <a16:rowId xmlns:a16="http://schemas.microsoft.com/office/drawing/2014/main" val="1978438622"/>
                  </a:ext>
                </a:extLst>
              </a:tr>
              <a:tr h="471063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b="1" kern="1200" dirty="0">
                          <a:solidFill>
                            <a:schemeClr val="l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Hydroxychloroquine</a:t>
                      </a:r>
                      <a:endParaRPr lang="pt-PT" sz="1400" b="1" kern="1200" dirty="0">
                        <a:solidFill>
                          <a:schemeClr val="lt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6 (12.9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76.9 (±86.3)</a:t>
                      </a:r>
                      <a:endParaRPr lang="pt-PT" sz="1400" kern="120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24840.0 (±40751.0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0.4 (±3.2)</a:t>
                      </a:r>
                      <a:endParaRPr lang="pt-PT" sz="140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51373" marR="51373" marT="0" marB="0"/>
                </a:tc>
                <a:extLst>
                  <a:ext uri="{0D108BD9-81ED-4DB2-BD59-A6C34878D82A}">
                    <a16:rowId xmlns:a16="http://schemas.microsoft.com/office/drawing/2014/main" val="2682645012"/>
                  </a:ext>
                </a:extLst>
              </a:tr>
              <a:tr h="1622233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</a:rPr>
                        <a:t>Combination therapy</a:t>
                      </a:r>
                      <a:endParaRPr lang="pt-PT" sz="1400" dirty="0">
                        <a:effectLst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</a:rPr>
                        <a:t>   Double therapy**</a:t>
                      </a:r>
                      <a:endParaRPr lang="pt-PT" sz="1400" dirty="0">
                        <a:effectLst/>
                      </a:endParaRPr>
                    </a:p>
                    <a:p>
                      <a:pPr algn="just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</a:rPr>
                        <a:t>   Triple therapy***</a:t>
                      </a:r>
                      <a:endParaRPr lang="pt-PT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373" marR="51373" marT="0" marB="0"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endParaRPr lang="en-US" sz="1400" dirty="0">
                        <a:effectLst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</a:rPr>
                        <a:t> 33 (16.3)</a:t>
                      </a:r>
                      <a:endParaRPr lang="pt-PT" sz="1400" dirty="0">
                        <a:effectLst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</a:rPr>
                        <a:t>28 (13.9)</a:t>
                      </a:r>
                      <a:endParaRPr lang="pt-PT" sz="1400" dirty="0">
                        <a:effectLst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</a:rPr>
                        <a:t>5 (2.5)</a:t>
                      </a:r>
                      <a:endParaRPr lang="pt-PT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373" marR="51373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  <a:endParaRPr lang="pt-PT" sz="1400" dirty="0">
                        <a:effectLst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</a:rPr>
                        <a:t>8.0 (±4.0)</a:t>
                      </a:r>
                      <a:endParaRPr lang="pt-PT" sz="1400" dirty="0">
                        <a:effectLst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</a:rPr>
                        <a:t>8.1 (±3.8)</a:t>
                      </a:r>
                      <a:endParaRPr lang="pt-PT" sz="1400" dirty="0">
                        <a:effectLst/>
                      </a:endParaRP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800"/>
                        </a:spcAft>
                      </a:pPr>
                      <a:r>
                        <a:rPr lang="en-US" sz="1400" dirty="0">
                          <a:effectLst/>
                        </a:rPr>
                        <a:t>7.2 (±4.5)</a:t>
                      </a:r>
                      <a:endParaRPr lang="pt-PT" sz="1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373" marR="51373" marT="0" marB="0"/>
                </a:tc>
                <a:extLst>
                  <a:ext uri="{0D108BD9-81ED-4DB2-BD59-A6C34878D82A}">
                    <a16:rowId xmlns:a16="http://schemas.microsoft.com/office/drawing/2014/main" val="3041022485"/>
                  </a:ext>
                </a:extLst>
              </a:tr>
            </a:tbl>
          </a:graphicData>
        </a:graphic>
      </p:graphicFrame>
      <p:sp>
        <p:nvSpPr>
          <p:cNvPr id="5" name="Título 1">
            <a:extLst>
              <a:ext uri="{FF2B5EF4-FFF2-40B4-BE49-F238E27FC236}">
                <a16:creationId xmlns:a16="http://schemas.microsoft.com/office/drawing/2014/main" id="{DCEC621E-A751-DA5E-12C6-9D1A0CC8A2CB}"/>
              </a:ext>
            </a:extLst>
          </p:cNvPr>
          <p:cNvSpPr txBox="1">
            <a:spLocks/>
          </p:cNvSpPr>
          <p:nvPr/>
        </p:nvSpPr>
        <p:spPr>
          <a:xfrm>
            <a:off x="0" y="185028"/>
            <a:ext cx="12192000" cy="972356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800" dirty="0" err="1">
                <a:solidFill>
                  <a:schemeClr val="bg1"/>
                </a:solidFill>
              </a:rPr>
              <a:t>Supl</a:t>
            </a:r>
            <a:r>
              <a:rPr lang="en-GB" sz="2800" dirty="0">
                <a:solidFill>
                  <a:schemeClr val="bg1"/>
                </a:solidFill>
              </a:rPr>
              <a:t>. Table 1: </a:t>
            </a:r>
            <a:r>
              <a:rPr lang="en-US" sz="2800" dirty="0">
                <a:solidFill>
                  <a:schemeClr val="bg1"/>
                </a:solidFill>
              </a:rPr>
              <a:t>Drug treatment details during the 12-month follow-up.</a:t>
            </a:r>
            <a:endParaRPr lang="pt-PT" sz="2800" dirty="0">
              <a:solidFill>
                <a:schemeClr val="bg1"/>
              </a:solidFill>
            </a:endParaRP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0705FCD8-3F74-CD48-0312-0A77EB7B70D8}"/>
              </a:ext>
            </a:extLst>
          </p:cNvPr>
          <p:cNvSpPr txBox="1"/>
          <p:nvPr/>
        </p:nvSpPr>
        <p:spPr>
          <a:xfrm>
            <a:off x="954158" y="6156112"/>
            <a:ext cx="10515598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*Number of patients and doses refer to the total of patients that ever received each therapy. **Double therapy refers to the combination of either methotrexate (or leflunomide) with sulfasalazine or hydroxychloroquine. **Triple therapy refers to the mutual combination of methotrexate (or leflunomide), sulfasalazine and hydroxychloroquine. No patient received a combination of methotrexate and leflunomide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295138173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ela 4">
            <a:extLst>
              <a:ext uri="{FF2B5EF4-FFF2-40B4-BE49-F238E27FC236}">
                <a16:creationId xmlns:a16="http://schemas.microsoft.com/office/drawing/2014/main" id="{C4A20DF2-6F36-29C1-4283-3797380E6B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59340011"/>
              </p:ext>
            </p:extLst>
          </p:nvPr>
        </p:nvGraphicFramePr>
        <p:xfrm>
          <a:off x="2435087" y="2136914"/>
          <a:ext cx="6768549" cy="3141581"/>
        </p:xfrm>
        <a:graphic>
          <a:graphicData uri="http://schemas.openxmlformats.org/drawingml/2006/table">
            <a:tbl>
              <a:tblPr firstRow="1" firstCol="1" bandRow="1">
                <a:tableStyleId>{0505E3EF-67EA-436B-97B2-0124C06EBD24}</a:tableStyleId>
              </a:tblPr>
              <a:tblGrid>
                <a:gridCol w="2091305">
                  <a:extLst>
                    <a:ext uri="{9D8B030D-6E8A-4147-A177-3AD203B41FA5}">
                      <a16:colId xmlns:a16="http://schemas.microsoft.com/office/drawing/2014/main" val="2309914342"/>
                    </a:ext>
                  </a:extLst>
                </a:gridCol>
                <a:gridCol w="1672389">
                  <a:extLst>
                    <a:ext uri="{9D8B030D-6E8A-4147-A177-3AD203B41FA5}">
                      <a16:colId xmlns:a16="http://schemas.microsoft.com/office/drawing/2014/main" val="2555339665"/>
                    </a:ext>
                  </a:extLst>
                </a:gridCol>
                <a:gridCol w="1711842">
                  <a:extLst>
                    <a:ext uri="{9D8B030D-6E8A-4147-A177-3AD203B41FA5}">
                      <a16:colId xmlns:a16="http://schemas.microsoft.com/office/drawing/2014/main" val="1386763562"/>
                    </a:ext>
                  </a:extLst>
                </a:gridCol>
                <a:gridCol w="1293013">
                  <a:extLst>
                    <a:ext uri="{9D8B030D-6E8A-4147-A177-3AD203B41FA5}">
                      <a16:colId xmlns:a16="http://schemas.microsoft.com/office/drawing/2014/main" val="4115690845"/>
                    </a:ext>
                  </a:extLst>
                </a:gridCol>
              </a:tblGrid>
              <a:tr h="484296">
                <a:tc gridSpan="4"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Rheumatoid Arthritis Patients, n (%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dirty="0"/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47645456"/>
                  </a:ext>
                </a:extLst>
              </a:tr>
              <a:tr h="720101"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effectLst/>
                        </a:rPr>
                        <a:t>Disease activity class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</a:rPr>
                        <a:t>Baseline</a:t>
                      </a:r>
                      <a:br>
                        <a:rPr lang="en-US" sz="1400">
                          <a:effectLst/>
                        </a:rPr>
                      </a:br>
                      <a:r>
                        <a:rPr lang="en-US" sz="1400">
                          <a:effectLst/>
                        </a:rPr>
                        <a:t>(n=116)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</a:rPr>
                        <a:t>Month 6</a:t>
                      </a:r>
                      <a:endParaRPr lang="pt-PT" sz="1400">
                        <a:effectLst/>
                      </a:endParaRPr>
                    </a:p>
                    <a:p>
                      <a:pPr algn="ctr"/>
                      <a:r>
                        <a:rPr lang="en-US" sz="1400">
                          <a:effectLst/>
                        </a:rPr>
                        <a:t>(n=113)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>
                          <a:effectLst/>
                        </a:rPr>
                        <a:t>Month 12</a:t>
                      </a:r>
                      <a:endParaRPr lang="pt-PT" sz="1400">
                        <a:effectLst/>
                      </a:endParaRPr>
                    </a:p>
                    <a:p>
                      <a:pPr algn="ctr"/>
                      <a:r>
                        <a:rPr lang="en-US" sz="1400">
                          <a:effectLst/>
                        </a:rPr>
                        <a:t>(n=88)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655195179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>
                          <a:effectLst/>
                        </a:rPr>
                        <a:t>HDA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2 (70.0)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20 (18.0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5 (5.7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2018542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>
                          <a:effectLst/>
                        </a:rPr>
                        <a:t>MDA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pt-PT" sz="14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4 (30.0)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71 (64.0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42 (47.7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35455542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>
                          <a:effectLst/>
                        </a:rPr>
                        <a:t>LDA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>
                          <a:effectLst/>
                        </a:rPr>
                        <a:t>0 (0)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10 (9.0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>
                          <a:effectLst/>
                        </a:rPr>
                        <a:t>23 (26.1)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23248468"/>
                  </a:ext>
                </a:extLst>
              </a:tr>
              <a:tr h="484296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>
                          <a:effectLst/>
                        </a:rPr>
                        <a:t>Remission</a:t>
                      </a:r>
                      <a:endParaRPr lang="pt-PT" sz="140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0 (0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10 (9.0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sz="1400" dirty="0">
                          <a:effectLst/>
                        </a:rPr>
                        <a:t>18 (20.4)</a:t>
                      </a:r>
                      <a:endParaRPr lang="pt-PT" sz="1400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831480388"/>
                  </a:ext>
                </a:extLst>
              </a:tr>
            </a:tbl>
          </a:graphicData>
        </a:graphic>
      </p:graphicFrame>
      <p:sp>
        <p:nvSpPr>
          <p:cNvPr id="10" name="Título 1">
            <a:extLst>
              <a:ext uri="{FF2B5EF4-FFF2-40B4-BE49-F238E27FC236}">
                <a16:creationId xmlns:a16="http://schemas.microsoft.com/office/drawing/2014/main" id="{020E0810-D25E-3367-E904-252F85B2775D}"/>
              </a:ext>
            </a:extLst>
          </p:cNvPr>
          <p:cNvSpPr txBox="1">
            <a:spLocks/>
          </p:cNvSpPr>
          <p:nvPr/>
        </p:nvSpPr>
        <p:spPr>
          <a:xfrm>
            <a:off x="0" y="185028"/>
            <a:ext cx="12192000" cy="972356"/>
          </a:xfrm>
          <a:prstGeom prst="rect">
            <a:avLst/>
          </a:prstGeom>
          <a:solidFill>
            <a:schemeClr val="tx2">
              <a:lumMod val="75000"/>
            </a:schemeClr>
          </a:solidFill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800" dirty="0" err="1">
                <a:solidFill>
                  <a:schemeClr val="bg1"/>
                </a:solidFill>
              </a:rPr>
              <a:t>Supl</a:t>
            </a:r>
            <a:r>
              <a:rPr lang="en-GB" sz="2800" dirty="0">
                <a:solidFill>
                  <a:schemeClr val="bg1"/>
                </a:solidFill>
              </a:rPr>
              <a:t>. Table 2A:  </a:t>
            </a:r>
            <a:r>
              <a:rPr lang="en-US" sz="2800" dirty="0">
                <a:solidFill>
                  <a:schemeClr val="bg1"/>
                </a:solidFill>
              </a:rPr>
              <a:t>RA patients disease activity groups at baseline, 6-months and 12-months according to the DAS-28-4V-ESR definition</a:t>
            </a:r>
            <a:endParaRPr lang="en-GB" sz="2800" dirty="0">
              <a:solidFill>
                <a:schemeClr val="bg1"/>
              </a:solidFill>
            </a:endParaRPr>
          </a:p>
        </p:txBody>
      </p:sp>
      <p:sp>
        <p:nvSpPr>
          <p:cNvPr id="11" name="CaixaDeTexto 10">
            <a:extLst>
              <a:ext uri="{FF2B5EF4-FFF2-40B4-BE49-F238E27FC236}">
                <a16:creationId xmlns:a16="http://schemas.microsoft.com/office/drawing/2014/main" id="{B78888DB-D1F9-B4E6-DCF4-EE27F05CA005}"/>
              </a:ext>
            </a:extLst>
          </p:cNvPr>
          <p:cNvSpPr txBox="1"/>
          <p:nvPr/>
        </p:nvSpPr>
        <p:spPr>
          <a:xfrm>
            <a:off x="2435087" y="5565913"/>
            <a:ext cx="66393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DA - High disease activity, defined as DAS28 greater than 5.1; MDA - moderate activity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fined as DAS28 between 3.2 and 5.1; LDA - low activity, defined asDAS28 between 2.6 and 3.2; remission as defined by DAS28 less than 2.6.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10119852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1431</Words>
  <Application>Microsoft Office PowerPoint</Application>
  <PresentationFormat>Ecrã Panorâmico</PresentationFormat>
  <Paragraphs>201</Paragraphs>
  <Slides>13</Slides>
  <Notes>0</Notes>
  <HiddenSlides>0</HiddenSlides>
  <MMClips>0</MMClips>
  <ScaleCrop>false</ScaleCrop>
  <HeadingPairs>
    <vt:vector size="8" baseType="variant">
      <vt:variant>
        <vt:lpstr>Tipos de letra usado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orporados</vt:lpstr>
      </vt:variant>
      <vt:variant>
        <vt:i4>2</vt:i4>
      </vt:variant>
      <vt:variant>
        <vt:lpstr>Títulos dos diapositivos</vt:lpstr>
      </vt:variant>
      <vt:variant>
        <vt:i4>13</vt:i4>
      </vt:variant>
    </vt:vector>
  </HeadingPairs>
  <TitlesOfParts>
    <vt:vector size="19" baseType="lpstr">
      <vt:lpstr>Arial</vt:lpstr>
      <vt:lpstr>Calibri</vt:lpstr>
      <vt:lpstr>Calibri Light</vt:lpstr>
      <vt:lpstr>Tema do Office</vt:lpstr>
      <vt:lpstr>Prism 8</vt:lpstr>
      <vt:lpstr>GraphPad Prism 8 Project</vt:lpstr>
      <vt:lpstr>Supplementary Material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ui Lourenço Teixeira</dc:creator>
  <cp:lastModifiedBy>Rui Lourenço Teixeira</cp:lastModifiedBy>
  <cp:revision>4</cp:revision>
  <dcterms:created xsi:type="dcterms:W3CDTF">2024-06-16T16:49:47Z</dcterms:created>
  <dcterms:modified xsi:type="dcterms:W3CDTF">2024-09-10T18:41:28Z</dcterms:modified>
</cp:coreProperties>
</file>